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348" y="-6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40239882805347"/>
          <c:y val="5.14002624671916E-2"/>
          <c:w val="0.68513855826161263"/>
          <c:h val="0.73771216097987746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2!$P$16</c:f>
              <c:strCache>
                <c:ptCount val="1"/>
                <c:pt idx="0">
                  <c:v>Plain DCN</c:v>
                </c:pt>
              </c:strCache>
            </c:strRef>
          </c:tx>
          <c:xVal>
            <c:numRef>
              <c:f>Sheet2!$O$17:$O$23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xVal>
          <c:yVal>
            <c:numRef>
              <c:f>Sheet2!$P$17:$P$23</c:f>
              <c:numCache>
                <c:formatCode>General</c:formatCode>
                <c:ptCount val="7"/>
                <c:pt idx="0">
                  <c:v>0</c:v>
                </c:pt>
                <c:pt idx="1">
                  <c:v>4.8899999999999997</c:v>
                </c:pt>
                <c:pt idx="2">
                  <c:v>9.6300000000000008</c:v>
                </c:pt>
                <c:pt idx="3">
                  <c:v>13.27</c:v>
                </c:pt>
                <c:pt idx="4">
                  <c:v>32.97</c:v>
                </c:pt>
                <c:pt idx="5">
                  <c:v>42.37</c:v>
                </c:pt>
                <c:pt idx="6">
                  <c:v>48.3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2!$Q$16</c:f>
              <c:strCache>
                <c:ptCount val="1"/>
                <c:pt idx="0">
                  <c:v>Optimized SD</c:v>
                </c:pt>
              </c:strCache>
            </c:strRef>
          </c:tx>
          <c:xVal>
            <c:numRef>
              <c:f>Sheet2!$O$17:$O$23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xVal>
          <c:yVal>
            <c:numRef>
              <c:f>Sheet2!$Q$17:$Q$23</c:f>
              <c:numCache>
                <c:formatCode>General</c:formatCode>
                <c:ptCount val="7"/>
                <c:pt idx="0">
                  <c:v>0</c:v>
                </c:pt>
                <c:pt idx="1">
                  <c:v>90.23</c:v>
                </c:pt>
                <c:pt idx="2">
                  <c:v>95.01</c:v>
                </c:pt>
                <c:pt idx="3">
                  <c:v>98.56</c:v>
                </c:pt>
                <c:pt idx="4">
                  <c:v>102.51</c:v>
                </c:pt>
                <c:pt idx="5">
                  <c:v>101.11</c:v>
                </c:pt>
                <c:pt idx="6">
                  <c:v>102.4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7930240"/>
        <c:axId val="177932160"/>
      </c:scatterChart>
      <c:valAx>
        <c:axId val="1779302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>
                    <a:latin typeface="Times New Roman" pitchFamily="18" charset="0"/>
                    <a:cs typeface="Times New Roman" pitchFamily="18" charset="0"/>
                  </a:rPr>
                  <a:t>Time (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7932160"/>
        <c:crosses val="autoZero"/>
        <c:crossBetween val="midCat"/>
      </c:valAx>
      <c:valAx>
        <c:axId val="1779321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>
                    <a:latin typeface="Times New Roman" pitchFamily="18" charset="0"/>
                    <a:cs typeface="Times New Roman" pitchFamily="18" charset="0"/>
                  </a:rPr>
                  <a:t>% DCN Dissolved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793024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71939479948727336"/>
          <c:y val="0.18998067949839606"/>
          <c:w val="0.27297656106940121"/>
          <c:h val="0.41170538057742784"/>
        </c:manualLayout>
      </c:layout>
      <c:overlay val="0"/>
      <c:txPr>
        <a:bodyPr/>
        <a:lstStyle/>
        <a:p>
          <a:pPr>
            <a:defRPr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342900072273575"/>
          <c:y val="0.15289634336805963"/>
          <c:w val="0.83024611054053021"/>
          <c:h val="0.63815427100048538"/>
        </c:manualLayout>
      </c:layout>
      <c:scatterChart>
        <c:scatterStyle val="lineMarker"/>
        <c:varyColors val="0"/>
        <c:ser>
          <c:idx val="1"/>
          <c:order val="1"/>
          <c:tx>
            <c:v>Plain DCN</c:v>
          </c:tx>
          <c:spPr>
            <a:ln w="19050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'Conc Profiles CSys(CPlasma)'!$D$38:$GU$38</c:f>
              <c:numCache>
                <c:formatCode>0.00</c:formatCode>
                <c:ptCount val="200"/>
                <c:pt idx="0">
                  <c:v>0</c:v>
                </c:pt>
                <c:pt idx="1">
                  <c:v>0.12006702274084093</c:v>
                </c:pt>
                <c:pt idx="2">
                  <c:v>0.2443259060382843</c:v>
                </c:pt>
                <c:pt idx="3">
                  <c:v>0.36030164361000067</c:v>
                </c:pt>
                <c:pt idx="4">
                  <c:v>0.48055621981620794</c:v>
                </c:pt>
                <c:pt idx="5">
                  <c:v>0.60424309968948375</c:v>
                </c:pt>
                <c:pt idx="6">
                  <c:v>0.72024452686309826</c:v>
                </c:pt>
                <c:pt idx="7">
                  <c:v>0.84160149097442649</c:v>
                </c:pt>
                <c:pt idx="8">
                  <c:v>0.96605563163757346</c:v>
                </c:pt>
                <c:pt idx="9">
                  <c:v>1.0866539478302004</c:v>
                </c:pt>
                <c:pt idx="10">
                  <c:v>1.2012778520584104</c:v>
                </c:pt>
                <c:pt idx="11">
                  <c:v>1.3260118961334229</c:v>
                </c:pt>
                <c:pt idx="12">
                  <c:v>1.4426530599594116</c:v>
                </c:pt>
                <c:pt idx="13">
                  <c:v>1.5690010786056519</c:v>
                </c:pt>
                <c:pt idx="14">
                  <c:v>1.6868789196014407</c:v>
                </c:pt>
                <c:pt idx="15">
                  <c:v>1.8051846027374265</c:v>
                </c:pt>
                <c:pt idx="16">
                  <c:v>1.923835873603821</c:v>
                </c:pt>
                <c:pt idx="17">
                  <c:v>2.0427603721618648</c:v>
                </c:pt>
                <c:pt idx="18">
                  <c:v>2.1619033813476567</c:v>
                </c:pt>
                <c:pt idx="19">
                  <c:v>2.2812161445617676</c:v>
                </c:pt>
                <c:pt idx="20">
                  <c:v>2.4006609916687003</c:v>
                </c:pt>
                <c:pt idx="21">
                  <c:v>2.5202214717864995</c:v>
                </c:pt>
                <c:pt idx="22">
                  <c:v>2.6490471363067627</c:v>
                </c:pt>
                <c:pt idx="23">
                  <c:v>2.7687909603118896</c:v>
                </c:pt>
                <c:pt idx="24">
                  <c:v>2.8883681297302237</c:v>
                </c:pt>
                <c:pt idx="25">
                  <c:v>3.0086979866027832</c:v>
                </c:pt>
                <c:pt idx="26">
                  <c:v>3.1285784244537349</c:v>
                </c:pt>
                <c:pt idx="27">
                  <c:v>3.2488002777099614</c:v>
                </c:pt>
                <c:pt idx="28">
                  <c:v>3.3613831996917725</c:v>
                </c:pt>
                <c:pt idx="29">
                  <c:v>3.4823369979858398</c:v>
                </c:pt>
                <c:pt idx="30">
                  <c:v>3.6031780242919926</c:v>
                </c:pt>
                <c:pt idx="31">
                  <c:v>3.7239062786102299</c:v>
                </c:pt>
                <c:pt idx="32">
                  <c:v>3.8445484638214107</c:v>
                </c:pt>
                <c:pt idx="33">
                  <c:v>3.9651341438293461</c:v>
                </c:pt>
                <c:pt idx="34">
                  <c:v>4.0857720375061035</c:v>
                </c:pt>
                <c:pt idx="35">
                  <c:v>4.2052946090698251</c:v>
                </c:pt>
                <c:pt idx="36">
                  <c:v>4.325655460357666</c:v>
                </c:pt>
                <c:pt idx="37">
                  <c:v>4.4455161094665518</c:v>
                </c:pt>
                <c:pt idx="38">
                  <c:v>4.5661420822143572</c:v>
                </c:pt>
                <c:pt idx="39">
                  <c:v>4.6875290870666495</c:v>
                </c:pt>
                <c:pt idx="40">
                  <c:v>4.8065848350524885</c:v>
                </c:pt>
                <c:pt idx="41">
                  <c:v>4.9269075393676758</c:v>
                </c:pt>
                <c:pt idx="42">
                  <c:v>5.0469059944152823</c:v>
                </c:pt>
                <c:pt idx="43">
                  <c:v>5.1673502922058097</c:v>
                </c:pt>
                <c:pt idx="44">
                  <c:v>5.2883195877075195</c:v>
                </c:pt>
                <c:pt idx="45">
                  <c:v>5.4087705612182617</c:v>
                </c:pt>
                <c:pt idx="46">
                  <c:v>5.5294737815856934</c:v>
                </c:pt>
                <c:pt idx="47">
                  <c:v>5.6498775482177717</c:v>
                </c:pt>
                <c:pt idx="48">
                  <c:v>5.7692241668701172</c:v>
                </c:pt>
                <c:pt idx="49">
                  <c:v>5.8890123367309561</c:v>
                </c:pt>
                <c:pt idx="50">
                  <c:v>6.0002098083496094</c:v>
                </c:pt>
                <c:pt idx="51">
                  <c:v>6.1214976310729972</c:v>
                </c:pt>
                <c:pt idx="52">
                  <c:v>6.2419314384460449</c:v>
                </c:pt>
                <c:pt idx="53">
                  <c:v>6.3610734939575204</c:v>
                </c:pt>
                <c:pt idx="54">
                  <c:v>6.4808378219604483</c:v>
                </c:pt>
                <c:pt idx="55">
                  <c:v>6.6017313003540039</c:v>
                </c:pt>
                <c:pt idx="56">
                  <c:v>6.7230377197265625</c:v>
                </c:pt>
                <c:pt idx="57">
                  <c:v>6.8420662879943857</c:v>
                </c:pt>
                <c:pt idx="58">
                  <c:v>6.9635491371154785</c:v>
                </c:pt>
                <c:pt idx="59">
                  <c:v>7.0825552940368652</c:v>
                </c:pt>
                <c:pt idx="60">
                  <c:v>7.2022137641906747</c:v>
                </c:pt>
                <c:pt idx="61">
                  <c:v>7.3232216835021982</c:v>
                </c:pt>
                <c:pt idx="62">
                  <c:v>7.4436712265014657</c:v>
                </c:pt>
                <c:pt idx="63">
                  <c:v>7.5646004676818848</c:v>
                </c:pt>
                <c:pt idx="64">
                  <c:v>7.6849994659423828</c:v>
                </c:pt>
                <c:pt idx="65">
                  <c:v>7.8045983314514151</c:v>
                </c:pt>
                <c:pt idx="66">
                  <c:v>7.9243316650390625</c:v>
                </c:pt>
                <c:pt idx="67">
                  <c:v>8.0451240539550781</c:v>
                </c:pt>
                <c:pt idx="68">
                  <c:v>8.1642961502075195</c:v>
                </c:pt>
                <c:pt idx="69">
                  <c:v>8.2853736877441388</c:v>
                </c:pt>
                <c:pt idx="70">
                  <c:v>8.4069957733154279</c:v>
                </c:pt>
                <c:pt idx="71">
                  <c:v>8.5259265899658203</c:v>
                </c:pt>
                <c:pt idx="72">
                  <c:v>8.6456365585327166</c:v>
                </c:pt>
                <c:pt idx="73">
                  <c:v>8.7666358947753924</c:v>
                </c:pt>
                <c:pt idx="74">
                  <c:v>8.8878889083862322</c:v>
                </c:pt>
                <c:pt idx="75">
                  <c:v>9.0069055557250994</c:v>
                </c:pt>
                <c:pt idx="76">
                  <c:v>9.1275815963745117</c:v>
                </c:pt>
                <c:pt idx="77">
                  <c:v>9.2473001480102521</c:v>
                </c:pt>
                <c:pt idx="78">
                  <c:v>9.3667840957641637</c:v>
                </c:pt>
                <c:pt idx="79">
                  <c:v>9.4888944625854492</c:v>
                </c:pt>
                <c:pt idx="80">
                  <c:v>9.6093244552612305</c:v>
                </c:pt>
                <c:pt idx="81">
                  <c:v>9.7296781539916974</c:v>
                </c:pt>
                <c:pt idx="82">
                  <c:v>9.8487787246704066</c:v>
                </c:pt>
                <c:pt idx="83">
                  <c:v>9.9685487747192401</c:v>
                </c:pt>
                <c:pt idx="84">
                  <c:v>10.081092834472656</c:v>
                </c:pt>
                <c:pt idx="85">
                  <c:v>10.201525688171385</c:v>
                </c:pt>
                <c:pt idx="86">
                  <c:v>10.320560455322267</c:v>
                </c:pt>
                <c:pt idx="87">
                  <c:v>10.441234588623049</c:v>
                </c:pt>
                <c:pt idx="88">
                  <c:v>10.560961723327637</c:v>
                </c:pt>
                <c:pt idx="89">
                  <c:v>10.680437088012697</c:v>
                </c:pt>
                <c:pt idx="90">
                  <c:v>10.802595138549808</c:v>
                </c:pt>
                <c:pt idx="91">
                  <c:v>10.922986030578617</c:v>
                </c:pt>
                <c:pt idx="92">
                  <c:v>11.041981697082518</c:v>
                </c:pt>
                <c:pt idx="93">
                  <c:v>11.16206169128418</c:v>
                </c:pt>
                <c:pt idx="94">
                  <c:v>11.282485008239748</c:v>
                </c:pt>
                <c:pt idx="95">
                  <c:v>11.401995658874512</c:v>
                </c:pt>
                <c:pt idx="96">
                  <c:v>11.524161338806151</c:v>
                </c:pt>
                <c:pt idx="97">
                  <c:v>11.644616127014158</c:v>
                </c:pt>
                <c:pt idx="98">
                  <c:v>11.763634681701662</c:v>
                </c:pt>
                <c:pt idx="99">
                  <c:v>11.883278846740723</c:v>
                </c:pt>
                <c:pt idx="100">
                  <c:v>12.125444412231447</c:v>
                </c:pt>
                <c:pt idx="101">
                  <c:v>12.245898246765137</c:v>
                </c:pt>
                <c:pt idx="102">
                  <c:v>12.364742279052736</c:v>
                </c:pt>
                <c:pt idx="103">
                  <c:v>12.485115051269533</c:v>
                </c:pt>
                <c:pt idx="104">
                  <c:v>12.604816436767578</c:v>
                </c:pt>
                <c:pt idx="105">
                  <c:v>12.725773811340332</c:v>
                </c:pt>
                <c:pt idx="106">
                  <c:v>12.846968650817869</c:v>
                </c:pt>
                <c:pt idx="107">
                  <c:v>12.966073989868164</c:v>
                </c:pt>
                <c:pt idx="108">
                  <c:v>13.08591938018799</c:v>
                </c:pt>
                <c:pt idx="109">
                  <c:v>13.207006454467773</c:v>
                </c:pt>
                <c:pt idx="110">
                  <c:v>13.327859878540041</c:v>
                </c:pt>
                <c:pt idx="111">
                  <c:v>13.447252273559569</c:v>
                </c:pt>
                <c:pt idx="112">
                  <c:v>13.567901611328125</c:v>
                </c:pt>
                <c:pt idx="113">
                  <c:v>13.687650680541992</c:v>
                </c:pt>
                <c:pt idx="114">
                  <c:v>13.807471275329592</c:v>
                </c:pt>
                <c:pt idx="115">
                  <c:v>13.920225143432615</c:v>
                </c:pt>
                <c:pt idx="116">
                  <c:v>14.049441337585451</c:v>
                </c:pt>
                <c:pt idx="117">
                  <c:v>14.169815063476561</c:v>
                </c:pt>
                <c:pt idx="118">
                  <c:v>14.28941822052002</c:v>
                </c:pt>
                <c:pt idx="119">
                  <c:v>14.409142494201662</c:v>
                </c:pt>
                <c:pt idx="120">
                  <c:v>14.521258354187012</c:v>
                </c:pt>
                <c:pt idx="121">
                  <c:v>14.641671180725096</c:v>
                </c:pt>
                <c:pt idx="122">
                  <c:v>14.760636329650879</c:v>
                </c:pt>
                <c:pt idx="123">
                  <c:v>14.880781173706056</c:v>
                </c:pt>
                <c:pt idx="124">
                  <c:v>15.001163482666014</c:v>
                </c:pt>
                <c:pt idx="125">
                  <c:v>15.12066078186035</c:v>
                </c:pt>
                <c:pt idx="126">
                  <c:v>15.242740631103516</c:v>
                </c:pt>
                <c:pt idx="127">
                  <c:v>15.363221168518065</c:v>
                </c:pt>
                <c:pt idx="128">
                  <c:v>15.482226371765138</c:v>
                </c:pt>
                <c:pt idx="129">
                  <c:v>15.601869583129883</c:v>
                </c:pt>
                <c:pt idx="130">
                  <c:v>15.722182273864748</c:v>
                </c:pt>
                <c:pt idx="131">
                  <c:v>15.843233108520508</c:v>
                </c:pt>
                <c:pt idx="132">
                  <c:v>15.964365005493162</c:v>
                </c:pt>
                <c:pt idx="133">
                  <c:v>16.083477020263672</c:v>
                </c:pt>
                <c:pt idx="134">
                  <c:v>16.203351974487301</c:v>
                </c:pt>
                <c:pt idx="135">
                  <c:v>16.324317932128903</c:v>
                </c:pt>
                <c:pt idx="136">
                  <c:v>16.443454742431637</c:v>
                </c:pt>
                <c:pt idx="137">
                  <c:v>16.565570831298825</c:v>
                </c:pt>
                <c:pt idx="138">
                  <c:v>16.68592453002929</c:v>
                </c:pt>
                <c:pt idx="139">
                  <c:v>16.804977416992195</c:v>
                </c:pt>
                <c:pt idx="140">
                  <c:v>16.924869537353516</c:v>
                </c:pt>
                <c:pt idx="141">
                  <c:v>17.045827865600589</c:v>
                </c:pt>
                <c:pt idx="142">
                  <c:v>17.16689491271973</c:v>
                </c:pt>
                <c:pt idx="143">
                  <c:v>17.287261962890629</c:v>
                </c:pt>
                <c:pt idx="144">
                  <c:v>17.406822204589837</c:v>
                </c:pt>
                <c:pt idx="145">
                  <c:v>17.527000427246097</c:v>
                </c:pt>
                <c:pt idx="146">
                  <c:v>17.646242141723626</c:v>
                </c:pt>
                <c:pt idx="147">
                  <c:v>17.767288208007812</c:v>
                </c:pt>
                <c:pt idx="148">
                  <c:v>17.888378143310547</c:v>
                </c:pt>
                <c:pt idx="149">
                  <c:v>18.008768081665036</c:v>
                </c:pt>
                <c:pt idx="150">
                  <c:v>18.128341674804688</c:v>
                </c:pt>
                <c:pt idx="151">
                  <c:v>18.248489379882809</c:v>
                </c:pt>
                <c:pt idx="152">
                  <c:v>18.367681503295895</c:v>
                </c:pt>
                <c:pt idx="153">
                  <c:v>18.480697631835927</c:v>
                </c:pt>
                <c:pt idx="154">
                  <c:v>18.610355377197269</c:v>
                </c:pt>
                <c:pt idx="155">
                  <c:v>18.729280471801754</c:v>
                </c:pt>
                <c:pt idx="156">
                  <c:v>18.840373992919922</c:v>
                </c:pt>
                <c:pt idx="157">
                  <c:v>18.961668014526364</c:v>
                </c:pt>
                <c:pt idx="158">
                  <c:v>19.08073806762695</c:v>
                </c:pt>
                <c:pt idx="159">
                  <c:v>19.202251434326172</c:v>
                </c:pt>
                <c:pt idx="160">
                  <c:v>19.321222305297852</c:v>
                </c:pt>
                <c:pt idx="161">
                  <c:v>19.440847396850589</c:v>
                </c:pt>
                <c:pt idx="162">
                  <c:v>19.5618896484375</c:v>
                </c:pt>
                <c:pt idx="163">
                  <c:v>19.683017730712887</c:v>
                </c:pt>
                <c:pt idx="164">
                  <c:v>19.802129745483391</c:v>
                </c:pt>
                <c:pt idx="165">
                  <c:v>19.922002792358391</c:v>
                </c:pt>
                <c:pt idx="166">
                  <c:v>20.042963027954105</c:v>
                </c:pt>
                <c:pt idx="167">
                  <c:v>20.162094116210938</c:v>
                </c:pt>
                <c:pt idx="168">
                  <c:v>20.284223556518551</c:v>
                </c:pt>
                <c:pt idx="169">
                  <c:v>20.404560089111325</c:v>
                </c:pt>
                <c:pt idx="170">
                  <c:v>20.523637771606442</c:v>
                </c:pt>
                <c:pt idx="171">
                  <c:v>20.643514633178707</c:v>
                </c:pt>
                <c:pt idx="172">
                  <c:v>20.76445198059082</c:v>
                </c:pt>
                <c:pt idx="173">
                  <c:v>20.885528564453121</c:v>
                </c:pt>
                <c:pt idx="174">
                  <c:v>21.005897521972656</c:v>
                </c:pt>
                <c:pt idx="175">
                  <c:v>21.125455856323239</c:v>
                </c:pt>
                <c:pt idx="176">
                  <c:v>21.245643615722649</c:v>
                </c:pt>
                <c:pt idx="177">
                  <c:v>21.364889144897464</c:v>
                </c:pt>
                <c:pt idx="178">
                  <c:v>21.485921859741204</c:v>
                </c:pt>
                <c:pt idx="179">
                  <c:v>21.607019424438484</c:v>
                </c:pt>
                <c:pt idx="180">
                  <c:v>21.727426528930661</c:v>
                </c:pt>
                <c:pt idx="181">
                  <c:v>21.84699821472168</c:v>
                </c:pt>
                <c:pt idx="182">
                  <c:v>21.967166900634766</c:v>
                </c:pt>
                <c:pt idx="183">
                  <c:v>22.086357116699222</c:v>
                </c:pt>
                <c:pt idx="184">
                  <c:v>22.207399368286133</c:v>
                </c:pt>
                <c:pt idx="185">
                  <c:v>22.329000473022461</c:v>
                </c:pt>
                <c:pt idx="186">
                  <c:v>22.447931289672852</c:v>
                </c:pt>
                <c:pt idx="187">
                  <c:v>22.567617416381832</c:v>
                </c:pt>
                <c:pt idx="188">
                  <c:v>22.680335998535153</c:v>
                </c:pt>
                <c:pt idx="189">
                  <c:v>22.80949783325195</c:v>
                </c:pt>
                <c:pt idx="190">
                  <c:v>22.920864105224613</c:v>
                </c:pt>
                <c:pt idx="191">
                  <c:v>23.050474166870121</c:v>
                </c:pt>
                <c:pt idx="192">
                  <c:v>23.169410705566406</c:v>
                </c:pt>
                <c:pt idx="193">
                  <c:v>23.280500411987298</c:v>
                </c:pt>
                <c:pt idx="194">
                  <c:v>23.401643753051754</c:v>
                </c:pt>
                <c:pt idx="195">
                  <c:v>23.520746231079094</c:v>
                </c:pt>
                <c:pt idx="196">
                  <c:v>23.640628814697266</c:v>
                </c:pt>
                <c:pt idx="197">
                  <c:v>23.761602401733388</c:v>
                </c:pt>
                <c:pt idx="198">
                  <c:v>23.880744934082024</c:v>
                </c:pt>
                <c:pt idx="199">
                  <c:v>24</c:v>
                </c:pt>
              </c:numCache>
            </c:numRef>
          </c:xVal>
          <c:yVal>
            <c:numRef>
              <c:f>'Conc Profiles CSys(CPlasma)'!$D$30:$GU$30</c:f>
              <c:numCache>
                <c:formatCode>0.00E+00</c:formatCode>
                <c:ptCount val="200"/>
                <c:pt idx="0">
                  <c:v>0</c:v>
                </c:pt>
                <c:pt idx="1">
                  <c:v>6.7256752634420993E-3</c:v>
                </c:pt>
                <c:pt idx="2">
                  <c:v>5.6071024388074875E-2</c:v>
                </c:pt>
                <c:pt idx="3">
                  <c:v>0.17724682763218882</c:v>
                </c:pt>
                <c:pt idx="4">
                  <c:v>0.39900123775005347</c:v>
                </c:pt>
                <c:pt idx="5">
                  <c:v>0.6965133130550385</c:v>
                </c:pt>
                <c:pt idx="6">
                  <c:v>1.0110254943370818</c:v>
                </c:pt>
                <c:pt idx="7">
                  <c:v>1.3318519592285158</c:v>
                </c:pt>
                <c:pt idx="8">
                  <c:v>1.6412139475345611</c:v>
                </c:pt>
                <c:pt idx="9">
                  <c:v>1.9134051799774172</c:v>
                </c:pt>
                <c:pt idx="10">
                  <c:v>2.1296980977058406</c:v>
                </c:pt>
                <c:pt idx="11">
                  <c:v>2.2915445089340212</c:v>
                </c:pt>
                <c:pt idx="12">
                  <c:v>2.404643940925598</c:v>
                </c:pt>
                <c:pt idx="13">
                  <c:v>2.4849342584609997</c:v>
                </c:pt>
                <c:pt idx="14">
                  <c:v>2.533092546463013</c:v>
                </c:pt>
                <c:pt idx="15">
                  <c:v>2.5585026383399962</c:v>
                </c:pt>
                <c:pt idx="16">
                  <c:v>2.5650215387344364</c:v>
                </c:pt>
                <c:pt idx="17">
                  <c:v>2.5567053198814387</c:v>
                </c:pt>
                <c:pt idx="18">
                  <c:v>2.5365845441818236</c:v>
                </c:pt>
                <c:pt idx="19">
                  <c:v>2.5074798822402955</c:v>
                </c:pt>
                <c:pt idx="20">
                  <c:v>2.4723744630813598</c:v>
                </c:pt>
                <c:pt idx="21">
                  <c:v>2.4309500575065615</c:v>
                </c:pt>
                <c:pt idx="22">
                  <c:v>2.3864889144897452</c:v>
                </c:pt>
                <c:pt idx="23">
                  <c:v>2.3385801553726195</c:v>
                </c:pt>
                <c:pt idx="24">
                  <c:v>2.2890897035598754</c:v>
                </c:pt>
                <c:pt idx="25">
                  <c:v>2.2374827384948732</c:v>
                </c:pt>
                <c:pt idx="26">
                  <c:v>2.1861348152160649</c:v>
                </c:pt>
                <c:pt idx="27">
                  <c:v>2.1338397026062017</c:v>
                </c:pt>
                <c:pt idx="28">
                  <c:v>2.0822869062423712</c:v>
                </c:pt>
                <c:pt idx="29">
                  <c:v>2.0307481765747064</c:v>
                </c:pt>
                <c:pt idx="30">
                  <c:v>1.978566300868988</c:v>
                </c:pt>
                <c:pt idx="31">
                  <c:v>1.9281343579292298</c:v>
                </c:pt>
                <c:pt idx="32">
                  <c:v>1.8782007217407231</c:v>
                </c:pt>
                <c:pt idx="33">
                  <c:v>1.829004955291748</c:v>
                </c:pt>
                <c:pt idx="34">
                  <c:v>1.7802658796310427</c:v>
                </c:pt>
                <c:pt idx="35">
                  <c:v>1.734082877635956</c:v>
                </c:pt>
                <c:pt idx="36">
                  <c:v>1.687293815612793</c:v>
                </c:pt>
                <c:pt idx="37">
                  <c:v>1.6418623924255369</c:v>
                </c:pt>
                <c:pt idx="38">
                  <c:v>1.5981366991996764</c:v>
                </c:pt>
                <c:pt idx="39">
                  <c:v>1.5550884723663332</c:v>
                </c:pt>
                <c:pt idx="40">
                  <c:v>1.512571531534195</c:v>
                </c:pt>
                <c:pt idx="41">
                  <c:v>1.4721423864364624</c:v>
                </c:pt>
                <c:pt idx="42">
                  <c:v>1.4317927181720729</c:v>
                </c:pt>
                <c:pt idx="43">
                  <c:v>1.3935206651687622</c:v>
                </c:pt>
                <c:pt idx="44">
                  <c:v>1.3557582974433897</c:v>
                </c:pt>
                <c:pt idx="45">
                  <c:v>1.3180514872074125</c:v>
                </c:pt>
                <c:pt idx="46">
                  <c:v>1.2831212043762208</c:v>
                </c:pt>
                <c:pt idx="47">
                  <c:v>1.2483084440231322</c:v>
                </c:pt>
                <c:pt idx="48">
                  <c:v>1.214163637161255</c:v>
                </c:pt>
                <c:pt idx="49">
                  <c:v>1.1811905801296234</c:v>
                </c:pt>
                <c:pt idx="50">
                  <c:v>1.1497983515262604</c:v>
                </c:pt>
                <c:pt idx="51">
                  <c:v>1.1182724297046664</c:v>
                </c:pt>
                <c:pt idx="52">
                  <c:v>1.0881448149681094</c:v>
                </c:pt>
                <c:pt idx="53">
                  <c:v>1.0585056245326998</c:v>
                </c:pt>
                <c:pt idx="54">
                  <c:v>1.0302617132663725</c:v>
                </c:pt>
                <c:pt idx="55">
                  <c:v>1.0021916031837461</c:v>
                </c:pt>
                <c:pt idx="56">
                  <c:v>0.9750651061534884</c:v>
                </c:pt>
                <c:pt idx="57">
                  <c:v>0.94901365339756028</c:v>
                </c:pt>
                <c:pt idx="58">
                  <c:v>0.92335247397422782</c:v>
                </c:pt>
                <c:pt idx="59">
                  <c:v>0.8986540466547015</c:v>
                </c:pt>
                <c:pt idx="60">
                  <c:v>0.87426227629184738</c:v>
                </c:pt>
                <c:pt idx="61">
                  <c:v>0.85116482079029088</c:v>
                </c:pt>
                <c:pt idx="62">
                  <c:v>0.82863928377628338</c:v>
                </c:pt>
                <c:pt idx="63">
                  <c:v>0.80621249973773945</c:v>
                </c:pt>
                <c:pt idx="64">
                  <c:v>0.78498024046421055</c:v>
                </c:pt>
                <c:pt idx="65">
                  <c:v>0.76402982771396644</c:v>
                </c:pt>
                <c:pt idx="66">
                  <c:v>0.7437436044216158</c:v>
                </c:pt>
                <c:pt idx="67">
                  <c:v>0.72417075932025909</c:v>
                </c:pt>
                <c:pt idx="68">
                  <c:v>0.70490321815013901</c:v>
                </c:pt>
                <c:pt idx="69">
                  <c:v>0.68617798388004292</c:v>
                </c:pt>
                <c:pt idx="70">
                  <c:v>0.66809507906436938</c:v>
                </c:pt>
                <c:pt idx="71">
                  <c:v>0.65042044818401346</c:v>
                </c:pt>
                <c:pt idx="72">
                  <c:v>0.63350659459829339</c:v>
                </c:pt>
                <c:pt idx="73">
                  <c:v>0.61683471500873577</c:v>
                </c:pt>
                <c:pt idx="74">
                  <c:v>0.60028116106986984</c:v>
                </c:pt>
                <c:pt idx="75">
                  <c:v>0.58512766063213351</c:v>
                </c:pt>
                <c:pt idx="76">
                  <c:v>0.5695733711123464</c:v>
                </c:pt>
                <c:pt idx="77">
                  <c:v>0.55451148599386202</c:v>
                </c:pt>
                <c:pt idx="78">
                  <c:v>0.54053466022014618</c:v>
                </c:pt>
                <c:pt idx="79">
                  <c:v>0.52616445422172542</c:v>
                </c:pt>
                <c:pt idx="80">
                  <c:v>0.51246870756149288</c:v>
                </c:pt>
                <c:pt idx="81">
                  <c:v>0.49935215413570411</c:v>
                </c:pt>
                <c:pt idx="82">
                  <c:v>0.48630563467741017</c:v>
                </c:pt>
                <c:pt idx="83">
                  <c:v>0.47368765175342564</c:v>
                </c:pt>
                <c:pt idx="84">
                  <c:v>0.46169600188732146</c:v>
                </c:pt>
                <c:pt idx="85">
                  <c:v>0.44971542358398431</c:v>
                </c:pt>
                <c:pt idx="86">
                  <c:v>0.43821156919002541</c:v>
                </c:pt>
                <c:pt idx="87">
                  <c:v>0.42709125876426696</c:v>
                </c:pt>
                <c:pt idx="88">
                  <c:v>0.41611859053373335</c:v>
                </c:pt>
                <c:pt idx="89">
                  <c:v>0.40536711141467102</c:v>
                </c:pt>
                <c:pt idx="90">
                  <c:v>0.39495753571391112</c:v>
                </c:pt>
                <c:pt idx="91">
                  <c:v>0.38487115874886524</c:v>
                </c:pt>
                <c:pt idx="92">
                  <c:v>0.37513344287872313</c:v>
                </c:pt>
                <c:pt idx="93">
                  <c:v>0.36563814580440535</c:v>
                </c:pt>
                <c:pt idx="94">
                  <c:v>0.35631265416741381</c:v>
                </c:pt>
                <c:pt idx="95">
                  <c:v>0.34739897102117545</c:v>
                </c:pt>
                <c:pt idx="96">
                  <c:v>0.33854433745145801</c:v>
                </c:pt>
                <c:pt idx="97">
                  <c:v>0.32994900345802308</c:v>
                </c:pt>
                <c:pt idx="98">
                  <c:v>0.32167725339531905</c:v>
                </c:pt>
                <c:pt idx="99">
                  <c:v>0.31367211863398559</c:v>
                </c:pt>
                <c:pt idx="100">
                  <c:v>0.29805900380015377</c:v>
                </c:pt>
                <c:pt idx="101">
                  <c:v>0.2906696192920209</c:v>
                </c:pt>
                <c:pt idx="102">
                  <c:v>0.28341930806636811</c:v>
                </c:pt>
                <c:pt idx="103">
                  <c:v>0.27614116370677949</c:v>
                </c:pt>
                <c:pt idx="104">
                  <c:v>0.26938179917633531</c:v>
                </c:pt>
                <c:pt idx="105">
                  <c:v>0.26272672526538376</c:v>
                </c:pt>
                <c:pt idx="106">
                  <c:v>0.25621349439024932</c:v>
                </c:pt>
                <c:pt idx="107">
                  <c:v>0.24983999766409401</c:v>
                </c:pt>
                <c:pt idx="108">
                  <c:v>0.24368272237479688</c:v>
                </c:pt>
                <c:pt idx="109">
                  <c:v>0.23760986737906933</c:v>
                </c:pt>
                <c:pt idx="110">
                  <c:v>0.2317984815686942</c:v>
                </c:pt>
                <c:pt idx="111">
                  <c:v>0.22610193900763989</c:v>
                </c:pt>
                <c:pt idx="112">
                  <c:v>0.22057784609496595</c:v>
                </c:pt>
                <c:pt idx="113">
                  <c:v>0.21515969559550288</c:v>
                </c:pt>
                <c:pt idx="114">
                  <c:v>0.20988578423857687</c:v>
                </c:pt>
                <c:pt idx="115">
                  <c:v>0.20480514690279963</c:v>
                </c:pt>
                <c:pt idx="116">
                  <c:v>0.19977131001651288</c:v>
                </c:pt>
                <c:pt idx="117">
                  <c:v>0.19489701986312868</c:v>
                </c:pt>
                <c:pt idx="118">
                  <c:v>0.19016097374260427</c:v>
                </c:pt>
                <c:pt idx="119">
                  <c:v>0.18560209423303603</c:v>
                </c:pt>
                <c:pt idx="120">
                  <c:v>0.1810165932402015</c:v>
                </c:pt>
                <c:pt idx="121">
                  <c:v>0.17665972169488667</c:v>
                </c:pt>
                <c:pt idx="122">
                  <c:v>0.17241199836134916</c:v>
                </c:pt>
                <c:pt idx="123">
                  <c:v>0.16821100506931544</c:v>
                </c:pt>
                <c:pt idx="124">
                  <c:v>0.16418972108513116</c:v>
                </c:pt>
                <c:pt idx="125">
                  <c:v>0.16025638505816461</c:v>
                </c:pt>
                <c:pt idx="126">
                  <c:v>0.15640262570232158</c:v>
                </c:pt>
                <c:pt idx="127">
                  <c:v>0.15267468653619293</c:v>
                </c:pt>
                <c:pt idx="128">
                  <c:v>0.14896005224436523</c:v>
                </c:pt>
                <c:pt idx="129">
                  <c:v>0.14541411809623248</c:v>
                </c:pt>
                <c:pt idx="130">
                  <c:v>0.14200143925845624</c:v>
                </c:pt>
                <c:pt idx="131">
                  <c:v>0.13857210446149115</c:v>
                </c:pt>
                <c:pt idx="132">
                  <c:v>0.13524218834936624</c:v>
                </c:pt>
                <c:pt idx="133">
                  <c:v>0.13213397823274137</c:v>
                </c:pt>
                <c:pt idx="134">
                  <c:v>0.12894528098404409</c:v>
                </c:pt>
                <c:pt idx="135">
                  <c:v>0.12589510995894668</c:v>
                </c:pt>
                <c:pt idx="136">
                  <c:v>0.12296836730092763</c:v>
                </c:pt>
                <c:pt idx="137">
                  <c:v>0.1200389684177935</c:v>
                </c:pt>
                <c:pt idx="138">
                  <c:v>0.1172085547819734</c:v>
                </c:pt>
                <c:pt idx="139">
                  <c:v>0.1144233511760831</c:v>
                </c:pt>
                <c:pt idx="140">
                  <c:v>0.11176370512694121</c:v>
                </c:pt>
                <c:pt idx="141">
                  <c:v>0.10911453794687989</c:v>
                </c:pt>
                <c:pt idx="142">
                  <c:v>0.10658049667254091</c:v>
                </c:pt>
                <c:pt idx="143">
                  <c:v>0.10411042990162971</c:v>
                </c:pt>
                <c:pt idx="144">
                  <c:v>0.10167668480426073</c:v>
                </c:pt>
                <c:pt idx="145">
                  <c:v>9.9291032273322352E-2</c:v>
                </c:pt>
                <c:pt idx="146">
                  <c:v>9.6988428011536593E-2</c:v>
                </c:pt>
                <c:pt idx="147">
                  <c:v>9.469093158841134E-2</c:v>
                </c:pt>
                <c:pt idx="148">
                  <c:v>9.2518701963126657E-2</c:v>
                </c:pt>
                <c:pt idx="149">
                  <c:v>9.0371130686253326E-2</c:v>
                </c:pt>
                <c:pt idx="150">
                  <c:v>8.8291938975453399E-2</c:v>
                </c:pt>
                <c:pt idx="151">
                  <c:v>8.6268104054033748E-2</c:v>
                </c:pt>
                <c:pt idx="152">
                  <c:v>8.4255480859428647E-2</c:v>
                </c:pt>
                <c:pt idx="153">
                  <c:v>8.2353247748687852E-2</c:v>
                </c:pt>
                <c:pt idx="154">
                  <c:v>8.046414302662018E-2</c:v>
                </c:pt>
                <c:pt idx="155">
                  <c:v>7.8573731891810911E-2</c:v>
                </c:pt>
                <c:pt idx="156">
                  <c:v>7.6766639482229962E-2</c:v>
                </c:pt>
                <c:pt idx="157">
                  <c:v>7.5054532196372759E-2</c:v>
                </c:pt>
                <c:pt idx="158">
                  <c:v>7.3324816860258574E-2</c:v>
                </c:pt>
                <c:pt idx="159">
                  <c:v>7.1674741199240083E-2</c:v>
                </c:pt>
                <c:pt idx="160">
                  <c:v>7.0023494726046936E-2</c:v>
                </c:pt>
                <c:pt idx="161">
                  <c:v>6.844032481312752E-2</c:v>
                </c:pt>
                <c:pt idx="162">
                  <c:v>6.6918165842071178E-2</c:v>
                </c:pt>
                <c:pt idx="163">
                  <c:v>6.5360657265409822E-2</c:v>
                </c:pt>
                <c:pt idx="164">
                  <c:v>6.3883287040516767E-2</c:v>
                </c:pt>
                <c:pt idx="165">
                  <c:v>6.2474041944369681E-2</c:v>
                </c:pt>
                <c:pt idx="166">
                  <c:v>6.1037677805870785E-2</c:v>
                </c:pt>
                <c:pt idx="167">
                  <c:v>5.9652267536148447E-2</c:v>
                </c:pt>
                <c:pt idx="168">
                  <c:v>5.8328205300495026E-2</c:v>
                </c:pt>
                <c:pt idx="169">
                  <c:v>5.7001886283978814E-2</c:v>
                </c:pt>
                <c:pt idx="170">
                  <c:v>5.5720788985490807E-2</c:v>
                </c:pt>
                <c:pt idx="171">
                  <c:v>5.4495832533575594E-2</c:v>
                </c:pt>
                <c:pt idx="172">
                  <c:v>5.3253213828429583E-2</c:v>
                </c:pt>
                <c:pt idx="173">
                  <c:v>5.2063684491440679E-2</c:v>
                </c:pt>
                <c:pt idx="174">
                  <c:v>5.0909274048171943E-2</c:v>
                </c:pt>
                <c:pt idx="175">
                  <c:v>4.9769296357408177E-2</c:v>
                </c:pt>
                <c:pt idx="176">
                  <c:v>4.865180503111332E-2</c:v>
                </c:pt>
                <c:pt idx="177">
                  <c:v>4.7582945087924607E-2</c:v>
                </c:pt>
                <c:pt idx="178">
                  <c:v>4.6543468674644817E-2</c:v>
                </c:pt>
                <c:pt idx="179">
                  <c:v>4.5484615466557451E-2</c:v>
                </c:pt>
                <c:pt idx="180">
                  <c:v>4.4496159604750576E-2</c:v>
                </c:pt>
                <c:pt idx="181">
                  <c:v>4.350416876841335E-2</c:v>
                </c:pt>
                <c:pt idx="182">
                  <c:v>4.2549119703471659E-2</c:v>
                </c:pt>
                <c:pt idx="183">
                  <c:v>4.161767843179405E-2</c:v>
                </c:pt>
                <c:pt idx="184">
                  <c:v>4.0691693965345638E-2</c:v>
                </c:pt>
                <c:pt idx="185">
                  <c:v>3.9797556633129713E-2</c:v>
                </c:pt>
                <c:pt idx="186">
                  <c:v>3.8943734695203604E-2</c:v>
                </c:pt>
                <c:pt idx="187">
                  <c:v>3.8065855705644941E-2</c:v>
                </c:pt>
                <c:pt idx="188">
                  <c:v>3.7232929002493628E-2</c:v>
                </c:pt>
                <c:pt idx="189">
                  <c:v>3.6434738419484358E-2</c:v>
                </c:pt>
                <c:pt idx="190">
                  <c:v>3.5636464995332053E-2</c:v>
                </c:pt>
                <c:pt idx="191">
                  <c:v>3.4859425248578192E-2</c:v>
                </c:pt>
                <c:pt idx="192">
                  <c:v>3.4111832559574402E-2</c:v>
                </c:pt>
                <c:pt idx="193">
                  <c:v>3.335833152523264E-2</c:v>
                </c:pt>
                <c:pt idx="194">
                  <c:v>3.2627770572435121E-2</c:v>
                </c:pt>
                <c:pt idx="195">
                  <c:v>3.1939644424710437E-2</c:v>
                </c:pt>
                <c:pt idx="196">
                  <c:v>3.1235356430988761E-2</c:v>
                </c:pt>
                <c:pt idx="197">
                  <c:v>3.0568724905606352E-2</c:v>
                </c:pt>
                <c:pt idx="198">
                  <c:v>2.9906664264854041E-2</c:v>
                </c:pt>
                <c:pt idx="199">
                  <c:v>2.9282723506912592E-2</c:v>
                </c:pt>
              </c:numCache>
            </c:numRef>
          </c:yVal>
          <c:smooth val="0"/>
        </c:ser>
        <c:ser>
          <c:idx val="2"/>
          <c:order val="2"/>
          <c:tx>
            <c:v>Optimized SD in healthy adults</c:v>
          </c:tx>
          <c:spPr>
            <a:ln w="19050">
              <a:solidFill>
                <a:srgbClr val="FFFF00"/>
              </a:solidFill>
              <a:prstDash val="solid"/>
            </a:ln>
          </c:spPr>
          <c:marker>
            <c:symbol val="none"/>
          </c:marker>
          <c:xVal>
            <c:numRef>
              <c:f>'[2]Conc Profiles CSys(CPlasma)'!$D$38:$GU$38</c:f>
              <c:numCache>
                <c:formatCode>0.00</c:formatCode>
                <c:ptCount val="200"/>
                <c:pt idx="0">
                  <c:v>0</c:v>
                </c:pt>
                <c:pt idx="1">
                  <c:v>0.12001849710941313</c:v>
                </c:pt>
                <c:pt idx="2">
                  <c:v>0.24001395702362063</c:v>
                </c:pt>
                <c:pt idx="3">
                  <c:v>0.36004245281219477</c:v>
                </c:pt>
                <c:pt idx="4">
                  <c:v>0.48002737760543834</c:v>
                </c:pt>
                <c:pt idx="5">
                  <c:v>0.60002458095550548</c:v>
                </c:pt>
                <c:pt idx="6">
                  <c:v>0.72000080347061179</c:v>
                </c:pt>
                <c:pt idx="7">
                  <c:v>0.84000658988952637</c:v>
                </c:pt>
                <c:pt idx="8">
                  <c:v>0.9600127339363097</c:v>
                </c:pt>
                <c:pt idx="9">
                  <c:v>1.0800037384033203</c:v>
                </c:pt>
                <c:pt idx="10">
                  <c:v>1.2040169239044189</c:v>
                </c:pt>
                <c:pt idx="11">
                  <c:v>1.3263050317764284</c:v>
                </c:pt>
                <c:pt idx="12">
                  <c:v>1.4508106708526609</c:v>
                </c:pt>
                <c:pt idx="13">
                  <c:v>1.5649983882904051</c:v>
                </c:pt>
                <c:pt idx="14">
                  <c:v>1.6831752061843872</c:v>
                </c:pt>
                <c:pt idx="15">
                  <c:v>1.8021157979965212</c:v>
                </c:pt>
                <c:pt idx="16">
                  <c:v>1.9294449090957644</c:v>
                </c:pt>
                <c:pt idx="17">
                  <c:v>2.0405931472778329</c:v>
                </c:pt>
                <c:pt idx="18">
                  <c:v>2.1601462364196782</c:v>
                </c:pt>
                <c:pt idx="19">
                  <c:v>2.284317255020142</c:v>
                </c:pt>
                <c:pt idx="20">
                  <c:v>2.4031069278717041</c:v>
                </c:pt>
                <c:pt idx="21">
                  <c:v>2.5216155052185054</c:v>
                </c:pt>
                <c:pt idx="22">
                  <c:v>2.6492645740509038</c:v>
                </c:pt>
                <c:pt idx="23">
                  <c:v>2.7702410221099854</c:v>
                </c:pt>
                <c:pt idx="24">
                  <c:v>2.8803040981292729</c:v>
                </c:pt>
                <c:pt idx="25">
                  <c:v>3.0070924758911137</c:v>
                </c:pt>
                <c:pt idx="26">
                  <c:v>3.1275656223297119</c:v>
                </c:pt>
                <c:pt idx="27">
                  <c:v>3.2489223480224618</c:v>
                </c:pt>
                <c:pt idx="28">
                  <c:v>3.3678243160247803</c:v>
                </c:pt>
                <c:pt idx="29">
                  <c:v>3.4879052639007573</c:v>
                </c:pt>
                <c:pt idx="30">
                  <c:v>3.6089644432067871</c:v>
                </c:pt>
                <c:pt idx="31">
                  <c:v>3.7274289131164551</c:v>
                </c:pt>
                <c:pt idx="32">
                  <c:v>3.8470380306243892</c:v>
                </c:pt>
                <c:pt idx="33">
                  <c:v>3.9680960178375249</c:v>
                </c:pt>
                <c:pt idx="34">
                  <c:v>4.0894494056701687</c:v>
                </c:pt>
                <c:pt idx="35">
                  <c:v>4.2081537246704102</c:v>
                </c:pt>
                <c:pt idx="36">
                  <c:v>4.3279223442077628</c:v>
                </c:pt>
                <c:pt idx="37">
                  <c:v>4.4408106803894043</c:v>
                </c:pt>
                <c:pt idx="38">
                  <c:v>4.5703520774841317</c:v>
                </c:pt>
                <c:pt idx="39">
                  <c:v>4.6891627311706552</c:v>
                </c:pt>
                <c:pt idx="40">
                  <c:v>4.8003153800964355</c:v>
                </c:pt>
                <c:pt idx="41">
                  <c:v>4.9216527938842791</c:v>
                </c:pt>
                <c:pt idx="42">
                  <c:v>5.0405406951904306</c:v>
                </c:pt>
                <c:pt idx="43">
                  <c:v>5.1602177619934073</c:v>
                </c:pt>
                <c:pt idx="44">
                  <c:v>5.2812299728393572</c:v>
                </c:pt>
                <c:pt idx="45">
                  <c:v>5.4024982452392578</c:v>
                </c:pt>
                <c:pt idx="46">
                  <c:v>5.5215015411376944</c:v>
                </c:pt>
                <c:pt idx="47">
                  <c:v>5.6413755416870108</c:v>
                </c:pt>
                <c:pt idx="48">
                  <c:v>5.7623248100280753</c:v>
                </c:pt>
                <c:pt idx="49">
                  <c:v>5.883512020111084</c:v>
                </c:pt>
                <c:pt idx="50">
                  <c:v>6.003891944885253</c:v>
                </c:pt>
                <c:pt idx="51">
                  <c:v>6.1226267814636239</c:v>
                </c:pt>
                <c:pt idx="52">
                  <c:v>6.2430753707885742</c:v>
                </c:pt>
                <c:pt idx="53">
                  <c:v>6.3625688552856445</c:v>
                </c:pt>
                <c:pt idx="54">
                  <c:v>6.4847145080566397</c:v>
                </c:pt>
                <c:pt idx="55">
                  <c:v>6.6052651405334473</c:v>
                </c:pt>
                <c:pt idx="56">
                  <c:v>6.7242336273193359</c:v>
                </c:pt>
                <c:pt idx="57">
                  <c:v>6.8438277244567871</c:v>
                </c:pt>
                <c:pt idx="58">
                  <c:v>6.9648480415344238</c:v>
                </c:pt>
                <c:pt idx="59">
                  <c:v>7.0860638618469238</c:v>
                </c:pt>
                <c:pt idx="60">
                  <c:v>7.2051367759704581</c:v>
                </c:pt>
                <c:pt idx="61">
                  <c:v>7.3251142501831046</c:v>
                </c:pt>
                <c:pt idx="62">
                  <c:v>7.4460296630859384</c:v>
                </c:pt>
                <c:pt idx="63">
                  <c:v>7.567187786102294</c:v>
                </c:pt>
                <c:pt idx="64">
                  <c:v>7.6862578392028809</c:v>
                </c:pt>
                <c:pt idx="65">
                  <c:v>7.806920051574707</c:v>
                </c:pt>
                <c:pt idx="66">
                  <c:v>7.9266648292541504</c:v>
                </c:pt>
                <c:pt idx="67">
                  <c:v>8.0480308532714826</c:v>
                </c:pt>
                <c:pt idx="68">
                  <c:v>8.1673460006713849</c:v>
                </c:pt>
                <c:pt idx="69">
                  <c:v>8.2889146804809553</c:v>
                </c:pt>
                <c:pt idx="70">
                  <c:v>8.4078483581542987</c:v>
                </c:pt>
                <c:pt idx="71">
                  <c:v>8.5274648666381836</c:v>
                </c:pt>
                <c:pt idx="72">
                  <c:v>8.640139579772951</c:v>
                </c:pt>
                <c:pt idx="73">
                  <c:v>8.7697849273681658</c:v>
                </c:pt>
                <c:pt idx="74">
                  <c:v>8.8888769149780273</c:v>
                </c:pt>
                <c:pt idx="75">
                  <c:v>9.0001125335693395</c:v>
                </c:pt>
                <c:pt idx="76">
                  <c:v>9.1212654113769513</c:v>
                </c:pt>
                <c:pt idx="77">
                  <c:v>9.2403383255004865</c:v>
                </c:pt>
                <c:pt idx="78">
                  <c:v>9.3610010147094727</c:v>
                </c:pt>
                <c:pt idx="79">
                  <c:v>9.480746269226076</c:v>
                </c:pt>
                <c:pt idx="80">
                  <c:v>9.6021080017089844</c:v>
                </c:pt>
                <c:pt idx="81">
                  <c:v>9.7214241027832031</c:v>
                </c:pt>
                <c:pt idx="82">
                  <c:v>9.8429899215698242</c:v>
                </c:pt>
                <c:pt idx="83">
                  <c:v>9.9619274139404279</c:v>
                </c:pt>
                <c:pt idx="84">
                  <c:v>10.081546783447267</c:v>
                </c:pt>
                <c:pt idx="85">
                  <c:v>10.202496528625492</c:v>
                </c:pt>
                <c:pt idx="86">
                  <c:v>10.323860168457031</c:v>
                </c:pt>
                <c:pt idx="87">
                  <c:v>10.442954063415526</c:v>
                </c:pt>
                <c:pt idx="88">
                  <c:v>10.56272602081299</c:v>
                </c:pt>
                <c:pt idx="89">
                  <c:v>10.683693885803224</c:v>
                </c:pt>
                <c:pt idx="90">
                  <c:v>10.804624557495119</c:v>
                </c:pt>
                <c:pt idx="91">
                  <c:v>10.92503547668457</c:v>
                </c:pt>
                <c:pt idx="92">
                  <c:v>11.044624328613281</c:v>
                </c:pt>
                <c:pt idx="93">
                  <c:v>11.164755821228027</c:v>
                </c:pt>
                <c:pt idx="94">
                  <c:v>11.283886909484865</c:v>
                </c:pt>
                <c:pt idx="95">
                  <c:v>11.405045509338381</c:v>
                </c:pt>
                <c:pt idx="96">
                  <c:v>11.525648117065431</c:v>
                </c:pt>
                <c:pt idx="97">
                  <c:v>11.645391464233397</c:v>
                </c:pt>
                <c:pt idx="98">
                  <c:v>11.765169143676758</c:v>
                </c:pt>
                <c:pt idx="99">
                  <c:v>11.886085510253908</c:v>
                </c:pt>
                <c:pt idx="100">
                  <c:v>12.126379966735838</c:v>
                </c:pt>
                <c:pt idx="101">
                  <c:v>12.246256828308105</c:v>
                </c:pt>
                <c:pt idx="102">
                  <c:v>12.367177963256834</c:v>
                </c:pt>
                <c:pt idx="103">
                  <c:v>12.488349914550781</c:v>
                </c:pt>
                <c:pt idx="104">
                  <c:v>12.608724594116213</c:v>
                </c:pt>
                <c:pt idx="105">
                  <c:v>12.727489471435547</c:v>
                </c:pt>
                <c:pt idx="106">
                  <c:v>12.847940444946289</c:v>
                </c:pt>
                <c:pt idx="107">
                  <c:v>12.967453002929691</c:v>
                </c:pt>
                <c:pt idx="108">
                  <c:v>13.089544296264654</c:v>
                </c:pt>
                <c:pt idx="109">
                  <c:v>13.210082054138184</c:v>
                </c:pt>
                <c:pt idx="110">
                  <c:v>13.329079627990723</c:v>
                </c:pt>
                <c:pt idx="111">
                  <c:v>13.440161705017088</c:v>
                </c:pt>
                <c:pt idx="112">
                  <c:v>13.5614070892334</c:v>
                </c:pt>
                <c:pt idx="113">
                  <c:v>13.680455207824709</c:v>
                </c:pt>
                <c:pt idx="114">
                  <c:v>13.800333023071289</c:v>
                </c:pt>
                <c:pt idx="115">
                  <c:v>13.92125415802002</c:v>
                </c:pt>
                <c:pt idx="116">
                  <c:v>14.04242515563965</c:v>
                </c:pt>
                <c:pt idx="117">
                  <c:v>14.162800788879396</c:v>
                </c:pt>
                <c:pt idx="118">
                  <c:v>14.281565666198729</c:v>
                </c:pt>
                <c:pt idx="119">
                  <c:v>14.402016639709476</c:v>
                </c:pt>
                <c:pt idx="120">
                  <c:v>14.521528244018553</c:v>
                </c:pt>
                <c:pt idx="121">
                  <c:v>14.64362049102783</c:v>
                </c:pt>
                <c:pt idx="122">
                  <c:v>14.764158248901367</c:v>
                </c:pt>
                <c:pt idx="123">
                  <c:v>14.883154869079592</c:v>
                </c:pt>
                <c:pt idx="124">
                  <c:v>15.002750396728517</c:v>
                </c:pt>
                <c:pt idx="125">
                  <c:v>15.123767852783205</c:v>
                </c:pt>
                <c:pt idx="126">
                  <c:v>15.244961738586422</c:v>
                </c:pt>
                <c:pt idx="127">
                  <c:v>15.364048957824709</c:v>
                </c:pt>
                <c:pt idx="128">
                  <c:v>15.484023094177246</c:v>
                </c:pt>
                <c:pt idx="129">
                  <c:v>15.604936599731447</c:v>
                </c:pt>
                <c:pt idx="130">
                  <c:v>15.726090431213377</c:v>
                </c:pt>
                <c:pt idx="131">
                  <c:v>15.845162391662599</c:v>
                </c:pt>
                <c:pt idx="132">
                  <c:v>15.965826034545902</c:v>
                </c:pt>
                <c:pt idx="133">
                  <c:v>16.085571289062496</c:v>
                </c:pt>
                <c:pt idx="134">
                  <c:v>16.206930160522461</c:v>
                </c:pt>
                <c:pt idx="135">
                  <c:v>16.32624626159668</c:v>
                </c:pt>
                <c:pt idx="136">
                  <c:v>16.447813034057617</c:v>
                </c:pt>
                <c:pt idx="137">
                  <c:v>16.566751480102539</c:v>
                </c:pt>
                <c:pt idx="138">
                  <c:v>16.686372756958008</c:v>
                </c:pt>
                <c:pt idx="139">
                  <c:v>16.807321548461911</c:v>
                </c:pt>
                <c:pt idx="140">
                  <c:v>16.928680419921868</c:v>
                </c:pt>
                <c:pt idx="141">
                  <c:v>17.047775268554691</c:v>
                </c:pt>
                <c:pt idx="142">
                  <c:v>17.167547225952145</c:v>
                </c:pt>
                <c:pt idx="143">
                  <c:v>17.280166625976563</c:v>
                </c:pt>
                <c:pt idx="144">
                  <c:v>17.409448623657227</c:v>
                </c:pt>
                <c:pt idx="145">
                  <c:v>17.52985763549805</c:v>
                </c:pt>
                <c:pt idx="146">
                  <c:v>17.649448394775384</c:v>
                </c:pt>
                <c:pt idx="147">
                  <c:v>17.761005401611328</c:v>
                </c:pt>
                <c:pt idx="148">
                  <c:v>17.88032341003418</c:v>
                </c:pt>
                <c:pt idx="149">
                  <c:v>18.001890182495121</c:v>
                </c:pt>
                <c:pt idx="150">
                  <c:v>18.12082672119141</c:v>
                </c:pt>
                <c:pt idx="151">
                  <c:v>18.240447998046871</c:v>
                </c:pt>
                <c:pt idx="152">
                  <c:v>18.361396789550781</c:v>
                </c:pt>
                <c:pt idx="153">
                  <c:v>18.482757568359368</c:v>
                </c:pt>
                <c:pt idx="154">
                  <c:v>18.601852416992195</c:v>
                </c:pt>
                <c:pt idx="155">
                  <c:v>18.721624374389641</c:v>
                </c:pt>
                <c:pt idx="156">
                  <c:v>18.842594146728516</c:v>
                </c:pt>
                <c:pt idx="157">
                  <c:v>18.963523864746087</c:v>
                </c:pt>
                <c:pt idx="158">
                  <c:v>19.083934783935543</c:v>
                </c:pt>
                <c:pt idx="159">
                  <c:v>19.203523635864251</c:v>
                </c:pt>
                <c:pt idx="160">
                  <c:v>19.323654174804691</c:v>
                </c:pt>
                <c:pt idx="161">
                  <c:v>19.44278526306152</c:v>
                </c:pt>
                <c:pt idx="162">
                  <c:v>19.563943862915036</c:v>
                </c:pt>
                <c:pt idx="163">
                  <c:v>19.68454742431641</c:v>
                </c:pt>
                <c:pt idx="164">
                  <c:v>19.804290771484375</c:v>
                </c:pt>
                <c:pt idx="165">
                  <c:v>19.924068450927731</c:v>
                </c:pt>
                <c:pt idx="166">
                  <c:v>20.044984817504886</c:v>
                </c:pt>
                <c:pt idx="167">
                  <c:v>20.166229248046871</c:v>
                </c:pt>
                <c:pt idx="168">
                  <c:v>20.2852783203125</c:v>
                </c:pt>
                <c:pt idx="169">
                  <c:v>20.405155181884769</c:v>
                </c:pt>
                <c:pt idx="170">
                  <c:v>20.526077270507809</c:v>
                </c:pt>
                <c:pt idx="171">
                  <c:v>20.647247314453125</c:v>
                </c:pt>
                <c:pt idx="172">
                  <c:v>20.767621994018555</c:v>
                </c:pt>
                <c:pt idx="173">
                  <c:v>20.886388778686527</c:v>
                </c:pt>
                <c:pt idx="174">
                  <c:v>21.006837844848633</c:v>
                </c:pt>
                <c:pt idx="175">
                  <c:v>21.126350402832031</c:v>
                </c:pt>
                <c:pt idx="176">
                  <c:v>21.248443603515618</c:v>
                </c:pt>
                <c:pt idx="177">
                  <c:v>21.368980407714844</c:v>
                </c:pt>
                <c:pt idx="178">
                  <c:v>21.487977981567379</c:v>
                </c:pt>
                <c:pt idx="179">
                  <c:v>21.607572555541989</c:v>
                </c:pt>
                <c:pt idx="180">
                  <c:v>21.720304489135739</c:v>
                </c:pt>
                <c:pt idx="181">
                  <c:v>21.849784851074219</c:v>
                </c:pt>
                <c:pt idx="182">
                  <c:v>21.968872070312496</c:v>
                </c:pt>
                <c:pt idx="183">
                  <c:v>22.08015251159668</c:v>
                </c:pt>
                <c:pt idx="184">
                  <c:v>22.201324462890629</c:v>
                </c:pt>
                <c:pt idx="185">
                  <c:v>22.321699142456055</c:v>
                </c:pt>
                <c:pt idx="186">
                  <c:v>22.440464019775384</c:v>
                </c:pt>
                <c:pt idx="187">
                  <c:v>22.560914993286133</c:v>
                </c:pt>
                <c:pt idx="188">
                  <c:v>22.680427551269524</c:v>
                </c:pt>
                <c:pt idx="189">
                  <c:v>22.802518844604492</c:v>
                </c:pt>
                <c:pt idx="190">
                  <c:v>22.92305755615234</c:v>
                </c:pt>
                <c:pt idx="191">
                  <c:v>23.04205322265625</c:v>
                </c:pt>
                <c:pt idx="192">
                  <c:v>23.161649703979489</c:v>
                </c:pt>
                <c:pt idx="193">
                  <c:v>23.282665252685543</c:v>
                </c:pt>
                <c:pt idx="194">
                  <c:v>23.403860092163086</c:v>
                </c:pt>
                <c:pt idx="195">
                  <c:v>23.522947311401364</c:v>
                </c:pt>
                <c:pt idx="196">
                  <c:v>23.642921447753906</c:v>
                </c:pt>
                <c:pt idx="197">
                  <c:v>23.763835906982425</c:v>
                </c:pt>
                <c:pt idx="198">
                  <c:v>23.884988784790043</c:v>
                </c:pt>
                <c:pt idx="199">
                  <c:v>24</c:v>
                </c:pt>
              </c:numCache>
            </c:numRef>
          </c:xVal>
          <c:yVal>
            <c:numRef>
              <c:f>'[2]Conc Profiles CSys(CPlasma)'!$D$30:$GU$30</c:f>
              <c:numCache>
                <c:formatCode>0.00E+00</c:formatCode>
                <c:ptCount val="200"/>
                <c:pt idx="0">
                  <c:v>0</c:v>
                </c:pt>
                <c:pt idx="1">
                  <c:v>0.17244860555976632</c:v>
                </c:pt>
                <c:pt idx="2">
                  <c:v>0.67776289492845543</c:v>
                </c:pt>
                <c:pt idx="3">
                  <c:v>1.3492232635617258</c:v>
                </c:pt>
                <c:pt idx="4">
                  <c:v>2.0654639738798135</c:v>
                </c:pt>
                <c:pt idx="5">
                  <c:v>2.7531648969650271</c:v>
                </c:pt>
                <c:pt idx="6">
                  <c:v>3.3737032067775736</c:v>
                </c:pt>
                <c:pt idx="7">
                  <c:v>3.9068744683265688</c:v>
                </c:pt>
                <c:pt idx="8">
                  <c:v>4.3500708234310146</c:v>
                </c:pt>
                <c:pt idx="9">
                  <c:v>4.705039236545562</c:v>
                </c:pt>
                <c:pt idx="10">
                  <c:v>4.9791728067398084</c:v>
                </c:pt>
                <c:pt idx="11">
                  <c:v>5.1808950448036191</c:v>
                </c:pt>
                <c:pt idx="12">
                  <c:v>5.3213555979728699</c:v>
                </c:pt>
                <c:pt idx="13">
                  <c:v>5.4104574918746966</c:v>
                </c:pt>
                <c:pt idx="14">
                  <c:v>5.4557596302032474</c:v>
                </c:pt>
                <c:pt idx="15">
                  <c:v>5.4659120011329652</c:v>
                </c:pt>
                <c:pt idx="16">
                  <c:v>5.4475120997428892</c:v>
                </c:pt>
                <c:pt idx="17">
                  <c:v>5.4055557370185845</c:v>
                </c:pt>
                <c:pt idx="18">
                  <c:v>5.3466234040260323</c:v>
                </c:pt>
                <c:pt idx="19">
                  <c:v>5.2729956603050221</c:v>
                </c:pt>
                <c:pt idx="20">
                  <c:v>5.1890129351615908</c:v>
                </c:pt>
                <c:pt idx="21">
                  <c:v>5.0970251703262317</c:v>
                </c:pt>
                <c:pt idx="22">
                  <c:v>4.99864135503769</c:v>
                </c:pt>
                <c:pt idx="23">
                  <c:v>4.8968037867546093</c:v>
                </c:pt>
                <c:pt idx="24">
                  <c:v>4.791591248512268</c:v>
                </c:pt>
                <c:pt idx="25">
                  <c:v>4.6850897979736335</c:v>
                </c:pt>
                <c:pt idx="26">
                  <c:v>4.5785987114906321</c:v>
                </c:pt>
                <c:pt idx="27">
                  <c:v>4.4713519287109387</c:v>
                </c:pt>
                <c:pt idx="28">
                  <c:v>4.3656431913375862</c:v>
                </c:pt>
                <c:pt idx="29">
                  <c:v>4.2609103322029096</c:v>
                </c:pt>
                <c:pt idx="30">
                  <c:v>4.1562603831291218</c:v>
                </c:pt>
                <c:pt idx="31">
                  <c:v>4.0545340204238887</c:v>
                </c:pt>
                <c:pt idx="32">
                  <c:v>3.9542767333984377</c:v>
                </c:pt>
                <c:pt idx="33">
                  <c:v>3.8554220700263979</c:v>
                </c:pt>
                <c:pt idx="34">
                  <c:v>3.7599424099922176</c:v>
                </c:pt>
                <c:pt idx="35">
                  <c:v>3.665879091024399</c:v>
                </c:pt>
                <c:pt idx="36">
                  <c:v>3.5736999857425689</c:v>
                </c:pt>
                <c:pt idx="37">
                  <c:v>3.4837022185325632</c:v>
                </c:pt>
                <c:pt idx="38">
                  <c:v>3.3958480107784261</c:v>
                </c:pt>
                <c:pt idx="39">
                  <c:v>3.3108320820331567</c:v>
                </c:pt>
                <c:pt idx="40">
                  <c:v>3.2270294547080995</c:v>
                </c:pt>
                <c:pt idx="41">
                  <c:v>3.1462007296085357</c:v>
                </c:pt>
                <c:pt idx="42">
                  <c:v>3.0672071766853342</c:v>
                </c:pt>
                <c:pt idx="43">
                  <c:v>2.9903307366371159</c:v>
                </c:pt>
                <c:pt idx="44">
                  <c:v>2.9150058460235591</c:v>
                </c:pt>
                <c:pt idx="45">
                  <c:v>2.8423092651367186</c:v>
                </c:pt>
                <c:pt idx="46">
                  <c:v>2.7714018762111667</c:v>
                </c:pt>
                <c:pt idx="47">
                  <c:v>2.7022381365299224</c:v>
                </c:pt>
                <c:pt idx="48">
                  <c:v>2.6346452128887177</c:v>
                </c:pt>
                <c:pt idx="49">
                  <c:v>2.5692731422185897</c:v>
                </c:pt>
                <c:pt idx="50">
                  <c:v>2.5055094093084334</c:v>
                </c:pt>
                <c:pt idx="51">
                  <c:v>2.4432498627901076</c:v>
                </c:pt>
                <c:pt idx="52">
                  <c:v>2.3831949168443685</c:v>
                </c:pt>
                <c:pt idx="53">
                  <c:v>2.3241869205236432</c:v>
                </c:pt>
                <c:pt idx="54">
                  <c:v>2.2670476824045185</c:v>
                </c:pt>
                <c:pt idx="55">
                  <c:v>2.2110663211345667</c:v>
                </c:pt>
                <c:pt idx="56">
                  <c:v>2.1571606647968293</c:v>
                </c:pt>
                <c:pt idx="57">
                  <c:v>2.1045616888999947</c:v>
                </c:pt>
                <c:pt idx="58">
                  <c:v>2.0532216411828998</c:v>
                </c:pt>
                <c:pt idx="59">
                  <c:v>2.0033204489946375</c:v>
                </c:pt>
                <c:pt idx="60">
                  <c:v>1.9545998090505601</c:v>
                </c:pt>
                <c:pt idx="61">
                  <c:v>1.9073107790946962</c:v>
                </c:pt>
                <c:pt idx="62">
                  <c:v>1.8611459600925448</c:v>
                </c:pt>
                <c:pt idx="63">
                  <c:v>1.8162507075071335</c:v>
                </c:pt>
                <c:pt idx="64">
                  <c:v>1.7729722407460213</c:v>
                </c:pt>
                <c:pt idx="65">
                  <c:v>1.7302226364612581</c:v>
                </c:pt>
                <c:pt idx="66">
                  <c:v>1.6889326635003092</c:v>
                </c:pt>
                <c:pt idx="67">
                  <c:v>1.648497907817364</c:v>
                </c:pt>
                <c:pt idx="68">
                  <c:v>1.6094182246923447</c:v>
                </c:pt>
                <c:pt idx="69">
                  <c:v>1.5711097928881641</c:v>
                </c:pt>
                <c:pt idx="70">
                  <c:v>1.5339735400676726</c:v>
                </c:pt>
                <c:pt idx="71">
                  <c:v>1.4977806860208509</c:v>
                </c:pt>
                <c:pt idx="72">
                  <c:v>1.4624228468537332</c:v>
                </c:pt>
                <c:pt idx="73">
                  <c:v>1.4280295068025588</c:v>
                </c:pt>
                <c:pt idx="74">
                  <c:v>1.3946168857812884</c:v>
                </c:pt>
                <c:pt idx="75">
                  <c:v>1.3618824154138565</c:v>
                </c:pt>
                <c:pt idx="76">
                  <c:v>1.3300727140903474</c:v>
                </c:pt>
                <c:pt idx="77">
                  <c:v>1.2992406372725962</c:v>
                </c:pt>
                <c:pt idx="78">
                  <c:v>1.2690527771413327</c:v>
                </c:pt>
                <c:pt idx="79">
                  <c:v>1.2395072861015797</c:v>
                </c:pt>
                <c:pt idx="80">
                  <c:v>1.2110101619362836</c:v>
                </c:pt>
                <c:pt idx="81">
                  <c:v>1.1830631230771542</c:v>
                </c:pt>
                <c:pt idx="82">
                  <c:v>1.1558385558426378</c:v>
                </c:pt>
                <c:pt idx="83">
                  <c:v>1.1293215747177601</c:v>
                </c:pt>
                <c:pt idx="84">
                  <c:v>1.1035122667253019</c:v>
                </c:pt>
                <c:pt idx="85">
                  <c:v>1.0781955201923847</c:v>
                </c:pt>
                <c:pt idx="86">
                  <c:v>1.0536944630742071</c:v>
                </c:pt>
                <c:pt idx="87">
                  <c:v>1.0297273963689801</c:v>
                </c:pt>
                <c:pt idx="88">
                  <c:v>1.0064246371388432</c:v>
                </c:pt>
                <c:pt idx="89">
                  <c:v>0.98356827557086934</c:v>
                </c:pt>
                <c:pt idx="90">
                  <c:v>0.96152585275471225</c:v>
                </c:pt>
                <c:pt idx="91">
                  <c:v>0.93984007544815562</c:v>
                </c:pt>
                <c:pt idx="92">
                  <c:v>0.91866170592606056</c:v>
                </c:pt>
                <c:pt idx="93">
                  <c:v>0.89803288884460919</c:v>
                </c:pt>
                <c:pt idx="94">
                  <c:v>0.87800677612423894</c:v>
                </c:pt>
                <c:pt idx="95">
                  <c:v>0.85839240744709977</c:v>
                </c:pt>
                <c:pt idx="96">
                  <c:v>0.83935962580144408</c:v>
                </c:pt>
                <c:pt idx="97">
                  <c:v>0.82069158837199219</c:v>
                </c:pt>
                <c:pt idx="98">
                  <c:v>0.80259261548519145</c:v>
                </c:pt>
                <c:pt idx="99">
                  <c:v>0.78476256147027001</c:v>
                </c:pt>
                <c:pt idx="100">
                  <c:v>0.75070344299077996</c:v>
                </c:pt>
                <c:pt idx="101">
                  <c:v>0.73408468272536997</c:v>
                </c:pt>
                <c:pt idx="102">
                  <c:v>0.71819072104990478</c:v>
                </c:pt>
                <c:pt idx="103">
                  <c:v>0.70237992841750385</c:v>
                </c:pt>
                <c:pt idx="104">
                  <c:v>0.68709837675094609</c:v>
                </c:pt>
                <c:pt idx="105">
                  <c:v>0.6721331409364939</c:v>
                </c:pt>
                <c:pt idx="106">
                  <c:v>0.65750925619155176</c:v>
                </c:pt>
                <c:pt idx="107">
                  <c:v>0.64332794331014165</c:v>
                </c:pt>
                <c:pt idx="108">
                  <c:v>0.62945281609892856</c:v>
                </c:pt>
                <c:pt idx="109">
                  <c:v>0.61585261620581178</c:v>
                </c:pt>
                <c:pt idx="110">
                  <c:v>0.60265600245445983</c:v>
                </c:pt>
                <c:pt idx="111">
                  <c:v>0.58973651226609958</c:v>
                </c:pt>
                <c:pt idx="112">
                  <c:v>0.57710256975144136</c:v>
                </c:pt>
                <c:pt idx="113">
                  <c:v>0.56473506709560761</c:v>
                </c:pt>
                <c:pt idx="114">
                  <c:v>0.55269888490438479</c:v>
                </c:pt>
                <c:pt idx="115">
                  <c:v>0.54096700051799418</c:v>
                </c:pt>
                <c:pt idx="116">
                  <c:v>0.52950881503522396</c:v>
                </c:pt>
                <c:pt idx="117">
                  <c:v>0.51826607055962071</c:v>
                </c:pt>
                <c:pt idx="118">
                  <c:v>0.50730127701535821</c:v>
                </c:pt>
                <c:pt idx="119">
                  <c:v>0.49663788067176939</c:v>
                </c:pt>
                <c:pt idx="120">
                  <c:v>0.48621225120499734</c:v>
                </c:pt>
                <c:pt idx="121">
                  <c:v>0.4759585064649583</c:v>
                </c:pt>
                <c:pt idx="122">
                  <c:v>0.46600333420559764</c:v>
                </c:pt>
                <c:pt idx="123">
                  <c:v>0.45626806765794764</c:v>
                </c:pt>
                <c:pt idx="124">
                  <c:v>0.44669773420318953</c:v>
                </c:pt>
                <c:pt idx="125">
                  <c:v>0.43745630748569975</c:v>
                </c:pt>
                <c:pt idx="126">
                  <c:v>0.42834301823750137</c:v>
                </c:pt>
                <c:pt idx="127">
                  <c:v>0.41949837419204428</c:v>
                </c:pt>
                <c:pt idx="128">
                  <c:v>0.41079250262118872</c:v>
                </c:pt>
                <c:pt idx="129">
                  <c:v>0.40230871227569887</c:v>
                </c:pt>
                <c:pt idx="130">
                  <c:v>0.39400322929024706</c:v>
                </c:pt>
                <c:pt idx="131">
                  <c:v>0.38592254066839821</c:v>
                </c:pt>
                <c:pt idx="132">
                  <c:v>0.37802131908945752</c:v>
                </c:pt>
                <c:pt idx="133">
                  <c:v>0.3702931490167975</c:v>
                </c:pt>
                <c:pt idx="134">
                  <c:v>0.36268992194905891</c:v>
                </c:pt>
                <c:pt idx="135">
                  <c:v>0.35533693114295611</c:v>
                </c:pt>
                <c:pt idx="136">
                  <c:v>0.34810454346239567</c:v>
                </c:pt>
                <c:pt idx="137">
                  <c:v>0.3410499087255448</c:v>
                </c:pt>
                <c:pt idx="138">
                  <c:v>0.33412662113085406</c:v>
                </c:pt>
                <c:pt idx="139">
                  <c:v>0.32736072136554883</c:v>
                </c:pt>
                <c:pt idx="140">
                  <c:v>0.3207620269199834</c:v>
                </c:pt>
                <c:pt idx="141">
                  <c:v>0.3143233601050453</c:v>
                </c:pt>
                <c:pt idx="142">
                  <c:v>0.30800667010247718</c:v>
                </c:pt>
                <c:pt idx="143">
                  <c:v>0.30177901674993335</c:v>
                </c:pt>
                <c:pt idx="144">
                  <c:v>0.2957433605240658</c:v>
                </c:pt>
                <c:pt idx="145">
                  <c:v>0.28982199818827226</c:v>
                </c:pt>
                <c:pt idx="146">
                  <c:v>0.28406899179331963</c:v>
                </c:pt>
                <c:pt idx="147">
                  <c:v>0.27839615998324013</c:v>
                </c:pt>
                <c:pt idx="148">
                  <c:v>0.27287977894768128</c:v>
                </c:pt>
                <c:pt idx="149">
                  <c:v>0.26747929922305053</c:v>
                </c:pt>
                <c:pt idx="150">
                  <c:v>0.26221029537264268</c:v>
                </c:pt>
                <c:pt idx="151">
                  <c:v>0.25705318337306382</c:v>
                </c:pt>
                <c:pt idx="152">
                  <c:v>0.25195912680355825</c:v>
                </c:pt>
                <c:pt idx="153">
                  <c:v>0.24698347433237364</c:v>
                </c:pt>
                <c:pt idx="154">
                  <c:v>0.24213899506255984</c:v>
                </c:pt>
                <c:pt idx="155">
                  <c:v>0.23739968101959674</c:v>
                </c:pt>
                <c:pt idx="156">
                  <c:v>0.23275421936530621</c:v>
                </c:pt>
                <c:pt idx="157">
                  <c:v>0.2282188774831593</c:v>
                </c:pt>
                <c:pt idx="158">
                  <c:v>0.22375892790034413</c:v>
                </c:pt>
                <c:pt idx="159">
                  <c:v>0.21940077643375841</c:v>
                </c:pt>
                <c:pt idx="160">
                  <c:v>0.21516223442973573</c:v>
                </c:pt>
                <c:pt idx="161">
                  <c:v>0.21097653904231267</c:v>
                </c:pt>
                <c:pt idx="162">
                  <c:v>0.20687915255781267</c:v>
                </c:pt>
                <c:pt idx="163">
                  <c:v>0.20290680692996829</c:v>
                </c:pt>
                <c:pt idx="164">
                  <c:v>0.19901726615964438</c:v>
                </c:pt>
                <c:pt idx="165">
                  <c:v>0.19518880166113375</c:v>
                </c:pt>
                <c:pt idx="166">
                  <c:v>0.19141376458690504</c:v>
                </c:pt>
                <c:pt idx="167">
                  <c:v>0.18774623582605279</c:v>
                </c:pt>
                <c:pt idx="168">
                  <c:v>0.18414848090964372</c:v>
                </c:pt>
                <c:pt idx="169">
                  <c:v>0.18065149267553351</c:v>
                </c:pt>
                <c:pt idx="170">
                  <c:v>0.17719926879624842</c:v>
                </c:pt>
                <c:pt idx="171">
                  <c:v>0.17383925701607952</c:v>
                </c:pt>
                <c:pt idx="172">
                  <c:v>0.17053354084957392</c:v>
                </c:pt>
                <c:pt idx="173">
                  <c:v>0.16731648263172252</c:v>
                </c:pt>
                <c:pt idx="174">
                  <c:v>0.16415501315263101</c:v>
                </c:pt>
                <c:pt idx="175">
                  <c:v>0.16105668718926611</c:v>
                </c:pt>
                <c:pt idx="176">
                  <c:v>0.15798522598750425</c:v>
                </c:pt>
                <c:pt idx="177">
                  <c:v>0.15504354094737216</c:v>
                </c:pt>
                <c:pt idx="178">
                  <c:v>0.15212970576481891</c:v>
                </c:pt>
                <c:pt idx="179">
                  <c:v>0.1492723390005995</c:v>
                </c:pt>
                <c:pt idx="180">
                  <c:v>0.14647188001952599</c:v>
                </c:pt>
                <c:pt idx="181">
                  <c:v>0.14373485590622298</c:v>
                </c:pt>
                <c:pt idx="182">
                  <c:v>0.14104868301423273</c:v>
                </c:pt>
                <c:pt idx="183">
                  <c:v>0.13842934250307737</c:v>
                </c:pt>
                <c:pt idx="184">
                  <c:v>0.13585298169462476</c:v>
                </c:pt>
                <c:pt idx="185">
                  <c:v>0.1333231156918919</c:v>
                </c:pt>
                <c:pt idx="186">
                  <c:v>0.13084990484290762</c:v>
                </c:pt>
                <c:pt idx="187">
                  <c:v>0.12843218699272263</c:v>
                </c:pt>
                <c:pt idx="188">
                  <c:v>0.12607239922625013</c:v>
                </c:pt>
                <c:pt idx="189">
                  <c:v>0.12373895163065755</c:v>
                </c:pt>
                <c:pt idx="190">
                  <c:v>0.12147065808065238</c:v>
                </c:pt>
                <c:pt idx="191">
                  <c:v>0.11924533074110515</c:v>
                </c:pt>
                <c:pt idx="192">
                  <c:v>0.11705225529120072</c:v>
                </c:pt>
                <c:pt idx="193">
                  <c:v>0.11491178649768699</c:v>
                </c:pt>
                <c:pt idx="194">
                  <c:v>0.11279970898496687</c:v>
                </c:pt>
                <c:pt idx="195">
                  <c:v>0.11075560208089882</c:v>
                </c:pt>
                <c:pt idx="196">
                  <c:v>0.10873309012589745</c:v>
                </c:pt>
                <c:pt idx="197">
                  <c:v>0.10675142748135844</c:v>
                </c:pt>
                <c:pt idx="198">
                  <c:v>0.10480978654115462</c:v>
                </c:pt>
                <c:pt idx="199">
                  <c:v>0.10298949694464681</c:v>
                </c:pt>
              </c:numCache>
            </c:numRef>
          </c:yVal>
          <c:smooth val="0"/>
        </c:ser>
        <c:ser>
          <c:idx val="0"/>
          <c:order val="0"/>
          <c:tx>
            <c:v>Optimized SD in Geriatrics</c:v>
          </c:tx>
          <c:spPr>
            <a:ln w="19050">
              <a:solidFill>
                <a:srgbClr val="00B050"/>
              </a:solidFill>
              <a:prstDash val="solid"/>
            </a:ln>
          </c:spPr>
          <c:marker>
            <c:symbol val="none"/>
          </c:marker>
          <c:xVal>
            <c:numRef>
              <c:f>'[3]Conc Profiles CSys(CPlasma)'!$D$38:$GU$38</c:f>
              <c:numCache>
                <c:formatCode>0.00</c:formatCode>
                <c:ptCount val="200"/>
                <c:pt idx="0">
                  <c:v>0</c:v>
                </c:pt>
                <c:pt idx="1">
                  <c:v>0.12002386152744293</c:v>
                </c:pt>
                <c:pt idx="2">
                  <c:v>0.24002265930175778</c:v>
                </c:pt>
                <c:pt idx="3">
                  <c:v>0.36001074314117432</c:v>
                </c:pt>
                <c:pt idx="4">
                  <c:v>0.48001176118850714</c:v>
                </c:pt>
                <c:pt idx="5">
                  <c:v>0.60000044107437145</c:v>
                </c:pt>
                <c:pt idx="6">
                  <c:v>0.72000759840011608</c:v>
                </c:pt>
                <c:pt idx="7">
                  <c:v>0.84000879526138317</c:v>
                </c:pt>
                <c:pt idx="8">
                  <c:v>0.96004223823547374</c:v>
                </c:pt>
                <c:pt idx="9">
                  <c:v>1.0800225734710696</c:v>
                </c:pt>
                <c:pt idx="10">
                  <c:v>1.2000017166137695</c:v>
                </c:pt>
                <c:pt idx="11">
                  <c:v>1.3200168609619143</c:v>
                </c:pt>
                <c:pt idx="12">
                  <c:v>1.4400378465652468</c:v>
                </c:pt>
                <c:pt idx="13">
                  <c:v>1.5622125864028933</c:v>
                </c:pt>
                <c:pt idx="14">
                  <c:v>1.6904624700546265</c:v>
                </c:pt>
                <c:pt idx="15">
                  <c:v>1.8045672178268433</c:v>
                </c:pt>
                <c:pt idx="16">
                  <c:v>1.9225143194198608</c:v>
                </c:pt>
                <c:pt idx="17">
                  <c:v>2.0411403179168701</c:v>
                </c:pt>
                <c:pt idx="18">
                  <c:v>2.1674270629882817</c:v>
                </c:pt>
                <c:pt idx="19">
                  <c:v>2.2859835624694833</c:v>
                </c:pt>
                <c:pt idx="20">
                  <c:v>2.4074230194091797</c:v>
                </c:pt>
                <c:pt idx="21">
                  <c:v>2.5267879962921147</c:v>
                </c:pt>
                <c:pt idx="22">
                  <c:v>2.6407504081726079</c:v>
                </c:pt>
                <c:pt idx="23">
                  <c:v>2.7610943317413339</c:v>
                </c:pt>
                <c:pt idx="24">
                  <c:v>2.8868830204010005</c:v>
                </c:pt>
                <c:pt idx="25">
                  <c:v>3.0073928833007813</c:v>
                </c:pt>
                <c:pt idx="26">
                  <c:v>3.1269404888153076</c:v>
                </c:pt>
                <c:pt idx="27">
                  <c:v>3.2454092502593999</c:v>
                </c:pt>
                <c:pt idx="28">
                  <c:v>3.3651971817016602</c:v>
                </c:pt>
                <c:pt idx="29">
                  <c:v>3.4853131771087642</c:v>
                </c:pt>
                <c:pt idx="30">
                  <c:v>3.6039578914642338</c:v>
                </c:pt>
                <c:pt idx="31">
                  <c:v>3.7228636741638179</c:v>
                </c:pt>
                <c:pt idx="32">
                  <c:v>3.8425664901733394</c:v>
                </c:pt>
                <c:pt idx="33">
                  <c:v>3.9631779193878178</c:v>
                </c:pt>
                <c:pt idx="34">
                  <c:v>4.0821261405944815</c:v>
                </c:pt>
                <c:pt idx="35">
                  <c:v>4.2025012969970694</c:v>
                </c:pt>
                <c:pt idx="36">
                  <c:v>4.321211338043212</c:v>
                </c:pt>
                <c:pt idx="37">
                  <c:v>4.4415407180786133</c:v>
                </c:pt>
                <c:pt idx="38">
                  <c:v>4.5614743232727051</c:v>
                </c:pt>
                <c:pt idx="39">
                  <c:v>4.6826162338256827</c:v>
                </c:pt>
                <c:pt idx="40">
                  <c:v>4.801220417022706</c:v>
                </c:pt>
                <c:pt idx="41">
                  <c:v>4.9207310676574698</c:v>
                </c:pt>
                <c:pt idx="42">
                  <c:v>5.0415234565734863</c:v>
                </c:pt>
                <c:pt idx="43">
                  <c:v>5.1626625061035156</c:v>
                </c:pt>
                <c:pt idx="44">
                  <c:v>5.2813730239868173</c:v>
                </c:pt>
                <c:pt idx="45">
                  <c:v>5.4008622169494629</c:v>
                </c:pt>
                <c:pt idx="46">
                  <c:v>5.5216770172119141</c:v>
                </c:pt>
                <c:pt idx="47">
                  <c:v>5.6427311897277823</c:v>
                </c:pt>
                <c:pt idx="48">
                  <c:v>5.7615766525268555</c:v>
                </c:pt>
                <c:pt idx="49">
                  <c:v>5.8812456130981463</c:v>
                </c:pt>
                <c:pt idx="50">
                  <c:v>6.001972198486329</c:v>
                </c:pt>
                <c:pt idx="51">
                  <c:v>6.1229672431945792</c:v>
                </c:pt>
                <c:pt idx="52">
                  <c:v>6.2431540489196777</c:v>
                </c:pt>
                <c:pt idx="53">
                  <c:v>6.3617115020751944</c:v>
                </c:pt>
                <c:pt idx="54">
                  <c:v>6.4819655418395996</c:v>
                </c:pt>
                <c:pt idx="55">
                  <c:v>6.6012768745422363</c:v>
                </c:pt>
                <c:pt idx="56">
                  <c:v>6.7231841087341309</c:v>
                </c:pt>
                <c:pt idx="57">
                  <c:v>6.8435406684875479</c:v>
                </c:pt>
                <c:pt idx="58">
                  <c:v>6.9623303413391104</c:v>
                </c:pt>
                <c:pt idx="59">
                  <c:v>7.0817303657531747</c:v>
                </c:pt>
                <c:pt idx="60">
                  <c:v>7.2025604248046893</c:v>
                </c:pt>
                <c:pt idx="61">
                  <c:v>7.3235611915588388</c:v>
                </c:pt>
                <c:pt idx="62">
                  <c:v>7.4424538612365714</c:v>
                </c:pt>
                <c:pt idx="63">
                  <c:v>7.5622243881225586</c:v>
                </c:pt>
                <c:pt idx="64">
                  <c:v>7.6829533576965314</c:v>
                </c:pt>
                <c:pt idx="65">
                  <c:v>7.8039188385009757</c:v>
                </c:pt>
                <c:pt idx="66">
                  <c:v>7.9227938652038574</c:v>
                </c:pt>
                <c:pt idx="67">
                  <c:v>8.0432643890380859</c:v>
                </c:pt>
                <c:pt idx="68">
                  <c:v>8.1628150939941406</c:v>
                </c:pt>
                <c:pt idx="69">
                  <c:v>8.2839736938476545</c:v>
                </c:pt>
                <c:pt idx="70">
                  <c:v>8.4030990600585938</c:v>
                </c:pt>
                <c:pt idx="71">
                  <c:v>8.5244779586791992</c:v>
                </c:pt>
                <c:pt idx="72">
                  <c:v>8.643220901489256</c:v>
                </c:pt>
                <c:pt idx="73">
                  <c:v>8.7626485824584961</c:v>
                </c:pt>
                <c:pt idx="74">
                  <c:v>8.8834028244018572</c:v>
                </c:pt>
                <c:pt idx="75">
                  <c:v>9.0045652389526367</c:v>
                </c:pt>
                <c:pt idx="76">
                  <c:v>9.1234645843505859</c:v>
                </c:pt>
                <c:pt idx="77">
                  <c:v>9.2430458068847656</c:v>
                </c:pt>
                <c:pt idx="78">
                  <c:v>9.3638238906860369</c:v>
                </c:pt>
                <c:pt idx="79">
                  <c:v>9.4845600128173828</c:v>
                </c:pt>
                <c:pt idx="80">
                  <c:v>9.6047763824462891</c:v>
                </c:pt>
                <c:pt idx="81">
                  <c:v>9.7241725921630859</c:v>
                </c:pt>
                <c:pt idx="82">
                  <c:v>9.8441047668457031</c:v>
                </c:pt>
                <c:pt idx="83">
                  <c:v>9.9630422592163121</c:v>
                </c:pt>
                <c:pt idx="84">
                  <c:v>10.084012031555174</c:v>
                </c:pt>
                <c:pt idx="85">
                  <c:v>10.204421043395994</c:v>
                </c:pt>
                <c:pt idx="86">
                  <c:v>10.323971748352049</c:v>
                </c:pt>
                <c:pt idx="87">
                  <c:v>10.443555831909181</c:v>
                </c:pt>
                <c:pt idx="88">
                  <c:v>10.564276695251465</c:v>
                </c:pt>
                <c:pt idx="89">
                  <c:v>10.685327529907228</c:v>
                </c:pt>
                <c:pt idx="90">
                  <c:v>10.804182052612306</c:v>
                </c:pt>
                <c:pt idx="91">
                  <c:v>10.923867225646974</c:v>
                </c:pt>
                <c:pt idx="92">
                  <c:v>11.044594764709473</c:v>
                </c:pt>
                <c:pt idx="93">
                  <c:v>11.165570259094242</c:v>
                </c:pt>
                <c:pt idx="94">
                  <c:v>11.285750389099121</c:v>
                </c:pt>
                <c:pt idx="95">
                  <c:v>11.404323577880858</c:v>
                </c:pt>
                <c:pt idx="96">
                  <c:v>11.524580001831055</c:v>
                </c:pt>
                <c:pt idx="97">
                  <c:v>11.643900871276854</c:v>
                </c:pt>
                <c:pt idx="98">
                  <c:v>11.765797615051271</c:v>
                </c:pt>
                <c:pt idx="99">
                  <c:v>11.886140823364261</c:v>
                </c:pt>
                <c:pt idx="100">
                  <c:v>12.124348640441893</c:v>
                </c:pt>
                <c:pt idx="101">
                  <c:v>12.245168685913082</c:v>
                </c:pt>
                <c:pt idx="102">
                  <c:v>12.366169929504398</c:v>
                </c:pt>
                <c:pt idx="103">
                  <c:v>12.485064506530763</c:v>
                </c:pt>
                <c:pt idx="104">
                  <c:v>12.604845046997069</c:v>
                </c:pt>
                <c:pt idx="105">
                  <c:v>12.725564002990723</c:v>
                </c:pt>
                <c:pt idx="106">
                  <c:v>12.846522331237795</c:v>
                </c:pt>
                <c:pt idx="107">
                  <c:v>12.965403556823734</c:v>
                </c:pt>
                <c:pt idx="108">
                  <c:v>13.085871696472168</c:v>
                </c:pt>
                <c:pt idx="109">
                  <c:v>13.205424308776855</c:v>
                </c:pt>
                <c:pt idx="110">
                  <c:v>13.326587677001957</c:v>
                </c:pt>
                <c:pt idx="111">
                  <c:v>13.445712089538572</c:v>
                </c:pt>
                <c:pt idx="112">
                  <c:v>13.567082405090332</c:v>
                </c:pt>
                <c:pt idx="113">
                  <c:v>13.685829162597654</c:v>
                </c:pt>
                <c:pt idx="114">
                  <c:v>13.805254936218265</c:v>
                </c:pt>
                <c:pt idx="115">
                  <c:v>13.926010131835937</c:v>
                </c:pt>
                <c:pt idx="116">
                  <c:v>14.047176361083983</c:v>
                </c:pt>
                <c:pt idx="117">
                  <c:v>14.166077613830565</c:v>
                </c:pt>
                <c:pt idx="118">
                  <c:v>14.285656929016115</c:v>
                </c:pt>
                <c:pt idx="119">
                  <c:v>14.406431198120119</c:v>
                </c:pt>
                <c:pt idx="120">
                  <c:v>14.527168273925781</c:v>
                </c:pt>
                <c:pt idx="121">
                  <c:v>14.647385597229004</c:v>
                </c:pt>
                <c:pt idx="122">
                  <c:v>14.766781806945803</c:v>
                </c:pt>
                <c:pt idx="123">
                  <c:v>14.886716842651369</c:v>
                </c:pt>
                <c:pt idx="124">
                  <c:v>15.005655288696291</c:v>
                </c:pt>
                <c:pt idx="125">
                  <c:v>15.126621246337891</c:v>
                </c:pt>
                <c:pt idx="126">
                  <c:v>15.247029304504395</c:v>
                </c:pt>
                <c:pt idx="127">
                  <c:v>15.366579055786136</c:v>
                </c:pt>
                <c:pt idx="128">
                  <c:v>15.486164093017578</c:v>
                </c:pt>
                <c:pt idx="129">
                  <c:v>15.60688591003418</c:v>
                </c:pt>
                <c:pt idx="130">
                  <c:v>15.727936744689943</c:v>
                </c:pt>
                <c:pt idx="131">
                  <c:v>15.84679126739502</c:v>
                </c:pt>
                <c:pt idx="132">
                  <c:v>15.966476440429691</c:v>
                </c:pt>
                <c:pt idx="133">
                  <c:v>16.087202072143548</c:v>
                </c:pt>
                <c:pt idx="134">
                  <c:v>16.20817947387695</c:v>
                </c:pt>
                <c:pt idx="135">
                  <c:v>16.328359603881832</c:v>
                </c:pt>
                <c:pt idx="136">
                  <c:v>16.446933746337884</c:v>
                </c:pt>
                <c:pt idx="137">
                  <c:v>16.567190170288089</c:v>
                </c:pt>
                <c:pt idx="138">
                  <c:v>16.68651008605957</c:v>
                </c:pt>
                <c:pt idx="139">
                  <c:v>16.808404922485352</c:v>
                </c:pt>
                <c:pt idx="140">
                  <c:v>16.928750991821286</c:v>
                </c:pt>
                <c:pt idx="141">
                  <c:v>17.047554016113281</c:v>
                </c:pt>
                <c:pt idx="142">
                  <c:v>17.166957855224613</c:v>
                </c:pt>
                <c:pt idx="143">
                  <c:v>17.287776947021481</c:v>
                </c:pt>
                <c:pt idx="144">
                  <c:v>17.408777236938473</c:v>
                </c:pt>
                <c:pt idx="145">
                  <c:v>17.52767372131348</c:v>
                </c:pt>
                <c:pt idx="146">
                  <c:v>17.647453308105472</c:v>
                </c:pt>
                <c:pt idx="147">
                  <c:v>17.76817321777343</c:v>
                </c:pt>
                <c:pt idx="148">
                  <c:v>17.889131546020504</c:v>
                </c:pt>
                <c:pt idx="149">
                  <c:v>18.008010864257813</c:v>
                </c:pt>
                <c:pt idx="150">
                  <c:v>18.128480911254886</c:v>
                </c:pt>
                <c:pt idx="151">
                  <c:v>18.248033523559567</c:v>
                </c:pt>
                <c:pt idx="152">
                  <c:v>18.369195938110352</c:v>
                </c:pt>
                <c:pt idx="153">
                  <c:v>18.480321884155266</c:v>
                </c:pt>
                <c:pt idx="154">
                  <c:v>18.609691619873047</c:v>
                </c:pt>
                <c:pt idx="155">
                  <c:v>18.728437423706051</c:v>
                </c:pt>
                <c:pt idx="156">
                  <c:v>18.847864151000984</c:v>
                </c:pt>
                <c:pt idx="157">
                  <c:v>18.960350036621087</c:v>
                </c:pt>
                <c:pt idx="158">
                  <c:v>19.089784622192383</c:v>
                </c:pt>
                <c:pt idx="159">
                  <c:v>19.208684921264645</c:v>
                </c:pt>
                <c:pt idx="160">
                  <c:v>19.328266143798828</c:v>
                </c:pt>
                <c:pt idx="161">
                  <c:v>19.440702438354489</c:v>
                </c:pt>
                <c:pt idx="162">
                  <c:v>19.569776535034176</c:v>
                </c:pt>
                <c:pt idx="163">
                  <c:v>19.680051803588867</c:v>
                </c:pt>
                <c:pt idx="164">
                  <c:v>19.809389114379883</c:v>
                </c:pt>
                <c:pt idx="165">
                  <c:v>19.920766830444329</c:v>
                </c:pt>
                <c:pt idx="166">
                  <c:v>20.048263549804687</c:v>
                </c:pt>
                <c:pt idx="167">
                  <c:v>20.161262512207028</c:v>
                </c:pt>
                <c:pt idx="168">
                  <c:v>20.280010223388672</c:v>
                </c:pt>
                <c:pt idx="169">
                  <c:v>20.409187316894531</c:v>
                </c:pt>
                <c:pt idx="170">
                  <c:v>20.520191192626953</c:v>
                </c:pt>
                <c:pt idx="171">
                  <c:v>20.641355514526367</c:v>
                </c:pt>
                <c:pt idx="172">
                  <c:v>20.760257720947266</c:v>
                </c:pt>
                <c:pt idx="173">
                  <c:v>20.889400482177727</c:v>
                </c:pt>
                <c:pt idx="174">
                  <c:v>21.000612258911126</c:v>
                </c:pt>
                <c:pt idx="175">
                  <c:v>21.121349334716793</c:v>
                </c:pt>
                <c:pt idx="176">
                  <c:v>21.241565704345703</c:v>
                </c:pt>
                <c:pt idx="177">
                  <c:v>21.360961914062504</c:v>
                </c:pt>
                <c:pt idx="178">
                  <c:v>21.48089599609375</c:v>
                </c:pt>
                <c:pt idx="179">
                  <c:v>21.609798431396488</c:v>
                </c:pt>
                <c:pt idx="180">
                  <c:v>21.720802307128903</c:v>
                </c:pt>
                <c:pt idx="181">
                  <c:v>21.84120941162109</c:v>
                </c:pt>
                <c:pt idx="182">
                  <c:v>21.960760116577141</c:v>
                </c:pt>
                <c:pt idx="183">
                  <c:v>22.080345153808594</c:v>
                </c:pt>
                <c:pt idx="184">
                  <c:v>22.201066970825188</c:v>
                </c:pt>
                <c:pt idx="185">
                  <c:v>22.322116851806637</c:v>
                </c:pt>
                <c:pt idx="186">
                  <c:v>22.440971374511719</c:v>
                </c:pt>
                <c:pt idx="187">
                  <c:v>22.5606575012207</c:v>
                </c:pt>
                <c:pt idx="188">
                  <c:v>22.68138313293457</c:v>
                </c:pt>
                <c:pt idx="189">
                  <c:v>22.802360534667965</c:v>
                </c:pt>
                <c:pt idx="190">
                  <c:v>22.922540664672848</c:v>
                </c:pt>
                <c:pt idx="191">
                  <c:v>23.04111289978027</c:v>
                </c:pt>
                <c:pt idx="192">
                  <c:v>23.161369323730472</c:v>
                </c:pt>
                <c:pt idx="193">
                  <c:v>23.280691146850589</c:v>
                </c:pt>
                <c:pt idx="194">
                  <c:v>23.402585983276364</c:v>
                </c:pt>
                <c:pt idx="195">
                  <c:v>23.522930145263672</c:v>
                </c:pt>
                <c:pt idx="196">
                  <c:v>23.641735076904293</c:v>
                </c:pt>
                <c:pt idx="197">
                  <c:v>23.761137008666989</c:v>
                </c:pt>
                <c:pt idx="198">
                  <c:v>23.881958007812507</c:v>
                </c:pt>
                <c:pt idx="199">
                  <c:v>24</c:v>
                </c:pt>
              </c:numCache>
            </c:numRef>
          </c:xVal>
          <c:yVal>
            <c:numRef>
              <c:f>'[3]Conc Profiles CSys(CPlasma)'!$D$30:$GU$30</c:f>
              <c:numCache>
                <c:formatCode>0.00E+00</c:formatCode>
                <c:ptCount val="200"/>
                <c:pt idx="0">
                  <c:v>0</c:v>
                </c:pt>
                <c:pt idx="1">
                  <c:v>0.1528318489715457</c:v>
                </c:pt>
                <c:pt idx="2">
                  <c:v>0.609959520250559</c:v>
                </c:pt>
                <c:pt idx="3">
                  <c:v>1.2228561368584636</c:v>
                </c:pt>
                <c:pt idx="4">
                  <c:v>1.8849288475513459</c:v>
                </c:pt>
                <c:pt idx="5">
                  <c:v>2.5234284496307371</c:v>
                </c:pt>
                <c:pt idx="6">
                  <c:v>3.107076362371445</c:v>
                </c:pt>
                <c:pt idx="7">
                  <c:v>3.6147048640251165</c:v>
                </c:pt>
                <c:pt idx="8">
                  <c:v>4.0393084454536456</c:v>
                </c:pt>
                <c:pt idx="9">
                  <c:v>4.3861670160293578</c:v>
                </c:pt>
                <c:pt idx="10">
                  <c:v>4.6599784159660338</c:v>
                </c:pt>
                <c:pt idx="11">
                  <c:v>4.8682858347892752</c:v>
                </c:pt>
                <c:pt idx="12">
                  <c:v>5.0182197380065912</c:v>
                </c:pt>
                <c:pt idx="13">
                  <c:v>5.1195045518875109</c:v>
                </c:pt>
                <c:pt idx="14">
                  <c:v>5.18034248828888</c:v>
                </c:pt>
                <c:pt idx="15">
                  <c:v>5.2071588778495776</c:v>
                </c:pt>
                <c:pt idx="16">
                  <c:v>5.2068004179000864</c:v>
                </c:pt>
                <c:pt idx="17">
                  <c:v>5.1835526585578906</c:v>
                </c:pt>
                <c:pt idx="18">
                  <c:v>5.1430678367614746</c:v>
                </c:pt>
                <c:pt idx="19">
                  <c:v>5.0880418848991402</c:v>
                </c:pt>
                <c:pt idx="20">
                  <c:v>5.0221778225898746</c:v>
                </c:pt>
                <c:pt idx="21">
                  <c:v>4.9482347583770752</c:v>
                </c:pt>
                <c:pt idx="22">
                  <c:v>4.8679798269271837</c:v>
                </c:pt>
                <c:pt idx="23">
                  <c:v>4.7834520173072805</c:v>
                </c:pt>
                <c:pt idx="24">
                  <c:v>4.6951453113555894</c:v>
                </c:pt>
                <c:pt idx="25">
                  <c:v>4.6046981048583984</c:v>
                </c:pt>
                <c:pt idx="26">
                  <c:v>4.5132648777961721</c:v>
                </c:pt>
                <c:pt idx="27">
                  <c:v>4.4218228697776798</c:v>
                </c:pt>
                <c:pt idx="28">
                  <c:v>4.3299769282341005</c:v>
                </c:pt>
                <c:pt idx="29">
                  <c:v>4.2383723449707036</c:v>
                </c:pt>
                <c:pt idx="30">
                  <c:v>4.1473783302307119</c:v>
                </c:pt>
                <c:pt idx="31">
                  <c:v>4.0587254118919374</c:v>
                </c:pt>
                <c:pt idx="32">
                  <c:v>3.9698196005821229</c:v>
                </c:pt>
                <c:pt idx="33">
                  <c:v>3.8831780314445492</c:v>
                </c:pt>
                <c:pt idx="34">
                  <c:v>3.7978164684772491</c:v>
                </c:pt>
                <c:pt idx="35">
                  <c:v>3.7143553507328035</c:v>
                </c:pt>
                <c:pt idx="36">
                  <c:v>3.6319728744029995</c:v>
                </c:pt>
                <c:pt idx="37">
                  <c:v>3.5516646373271943</c:v>
                </c:pt>
                <c:pt idx="38">
                  <c:v>3.4732107448577882</c:v>
                </c:pt>
                <c:pt idx="39">
                  <c:v>3.3959745466709146</c:v>
                </c:pt>
                <c:pt idx="40">
                  <c:v>3.3207240104675297</c:v>
                </c:pt>
                <c:pt idx="41">
                  <c:v>3.2473739016056067</c:v>
                </c:pt>
                <c:pt idx="42">
                  <c:v>3.1757016754150391</c:v>
                </c:pt>
                <c:pt idx="43">
                  <c:v>3.1056119287014012</c:v>
                </c:pt>
                <c:pt idx="44">
                  <c:v>3.0370929265022277</c:v>
                </c:pt>
                <c:pt idx="45">
                  <c:v>2.9697864460945134</c:v>
                </c:pt>
                <c:pt idx="46">
                  <c:v>2.9047770285606389</c:v>
                </c:pt>
                <c:pt idx="47">
                  <c:v>2.8407654762268062</c:v>
                </c:pt>
                <c:pt idx="48">
                  <c:v>2.7785099422931672</c:v>
                </c:pt>
                <c:pt idx="49">
                  <c:v>2.7175750350952148</c:v>
                </c:pt>
                <c:pt idx="50">
                  <c:v>2.6581082892417909</c:v>
                </c:pt>
                <c:pt idx="51">
                  <c:v>2.6003397113084796</c:v>
                </c:pt>
                <c:pt idx="52">
                  <c:v>2.5438722473382951</c:v>
                </c:pt>
                <c:pt idx="53">
                  <c:v>2.4888374447822574</c:v>
                </c:pt>
                <c:pt idx="54">
                  <c:v>2.4345610755681988</c:v>
                </c:pt>
                <c:pt idx="55">
                  <c:v>2.3819583046436303</c:v>
                </c:pt>
                <c:pt idx="56">
                  <c:v>2.3307752543687816</c:v>
                </c:pt>
                <c:pt idx="57">
                  <c:v>2.2804290789365775</c:v>
                </c:pt>
                <c:pt idx="58">
                  <c:v>2.2316103172302242</c:v>
                </c:pt>
                <c:pt idx="59">
                  <c:v>2.1837681698799138</c:v>
                </c:pt>
                <c:pt idx="60">
                  <c:v>2.1372186255455015</c:v>
                </c:pt>
                <c:pt idx="61">
                  <c:v>2.0916492849588386</c:v>
                </c:pt>
                <c:pt idx="62">
                  <c:v>2.0472822207212449</c:v>
                </c:pt>
                <c:pt idx="63">
                  <c:v>2.003444082140923</c:v>
                </c:pt>
                <c:pt idx="64">
                  <c:v>1.961150137782097</c:v>
                </c:pt>
                <c:pt idx="65">
                  <c:v>1.9200446659326553</c:v>
                </c:pt>
                <c:pt idx="66">
                  <c:v>1.8793168807029721</c:v>
                </c:pt>
                <c:pt idx="67">
                  <c:v>1.8398929172754286</c:v>
                </c:pt>
                <c:pt idx="68">
                  <c:v>1.8014406943321226</c:v>
                </c:pt>
                <c:pt idx="69">
                  <c:v>1.7636353898048398</c:v>
                </c:pt>
                <c:pt idx="70">
                  <c:v>1.7267527958750726</c:v>
                </c:pt>
                <c:pt idx="71">
                  <c:v>1.6908517667651179</c:v>
                </c:pt>
                <c:pt idx="72">
                  <c:v>1.6558470815420152</c:v>
                </c:pt>
                <c:pt idx="73">
                  <c:v>1.6212882938981057</c:v>
                </c:pt>
                <c:pt idx="74">
                  <c:v>1.5877199810743332</c:v>
                </c:pt>
                <c:pt idx="75">
                  <c:v>1.5550618013739586</c:v>
                </c:pt>
                <c:pt idx="76">
                  <c:v>1.5231174856424332</c:v>
                </c:pt>
                <c:pt idx="77">
                  <c:v>1.4917752149701118</c:v>
                </c:pt>
                <c:pt idx="78">
                  <c:v>1.4612235510349272</c:v>
                </c:pt>
                <c:pt idx="79">
                  <c:v>1.4313513144850729</c:v>
                </c:pt>
                <c:pt idx="80">
                  <c:v>1.4020317879319188</c:v>
                </c:pt>
                <c:pt idx="81">
                  <c:v>1.3735971727967264</c:v>
                </c:pt>
                <c:pt idx="82">
                  <c:v>1.3457934068143365</c:v>
                </c:pt>
                <c:pt idx="83">
                  <c:v>1.3184058167040349</c:v>
                </c:pt>
                <c:pt idx="84">
                  <c:v>1.2918817788362502</c:v>
                </c:pt>
                <c:pt idx="85">
                  <c:v>1.2658245402574535</c:v>
                </c:pt>
                <c:pt idx="86">
                  <c:v>1.2403399831056594</c:v>
                </c:pt>
                <c:pt idx="87">
                  <c:v>1.2156151820719241</c:v>
                </c:pt>
                <c:pt idx="88">
                  <c:v>1.1912363907694814</c:v>
                </c:pt>
                <c:pt idx="89">
                  <c:v>1.1673874700069429</c:v>
                </c:pt>
                <c:pt idx="90">
                  <c:v>1.14412261351943</c:v>
                </c:pt>
                <c:pt idx="91">
                  <c:v>1.121390558630228</c:v>
                </c:pt>
                <c:pt idx="92">
                  <c:v>1.0990760968625546</c:v>
                </c:pt>
                <c:pt idx="93">
                  <c:v>1.0773825334012512</c:v>
                </c:pt>
                <c:pt idx="94">
                  <c:v>1.0560456490516663</c:v>
                </c:pt>
                <c:pt idx="95">
                  <c:v>1.035403971672058</c:v>
                </c:pt>
                <c:pt idx="96">
                  <c:v>1.0148854391276838</c:v>
                </c:pt>
                <c:pt idx="97">
                  <c:v>0.99502630777657031</c:v>
                </c:pt>
                <c:pt idx="98">
                  <c:v>0.97557900041341794</c:v>
                </c:pt>
                <c:pt idx="99">
                  <c:v>0.95646411836147305</c:v>
                </c:pt>
                <c:pt idx="100">
                  <c:v>0.91964649200439474</c:v>
                </c:pt>
                <c:pt idx="101">
                  <c:v>0.90181319303810592</c:v>
                </c:pt>
                <c:pt idx="102">
                  <c:v>0.8843462963402271</c:v>
                </c:pt>
                <c:pt idx="103">
                  <c:v>0.86725608572363844</c:v>
                </c:pt>
                <c:pt idx="104">
                  <c:v>0.85060297884047043</c:v>
                </c:pt>
                <c:pt idx="105">
                  <c:v>0.83423756331205356</c:v>
                </c:pt>
                <c:pt idx="106">
                  <c:v>0.81824757866561415</c:v>
                </c:pt>
                <c:pt idx="107">
                  <c:v>0.80262657292187223</c:v>
                </c:pt>
                <c:pt idx="108">
                  <c:v>0.78721124142408372</c:v>
                </c:pt>
                <c:pt idx="109">
                  <c:v>0.7722172418981792</c:v>
                </c:pt>
                <c:pt idx="110">
                  <c:v>0.75755099512636659</c:v>
                </c:pt>
                <c:pt idx="111">
                  <c:v>0.74318352721631531</c:v>
                </c:pt>
                <c:pt idx="112">
                  <c:v>0.72914598383009444</c:v>
                </c:pt>
                <c:pt idx="113">
                  <c:v>0.71534603200852886</c:v>
                </c:pt>
                <c:pt idx="114">
                  <c:v>0.7017857095226645</c:v>
                </c:pt>
                <c:pt idx="115">
                  <c:v>0.68867377486079939</c:v>
                </c:pt>
                <c:pt idx="116">
                  <c:v>0.67572607830166831</c:v>
                </c:pt>
                <c:pt idx="117">
                  <c:v>0.66307872984558369</c:v>
                </c:pt>
                <c:pt idx="118">
                  <c:v>0.65067883927375103</c:v>
                </c:pt>
                <c:pt idx="119">
                  <c:v>0.6385119340941311</c:v>
                </c:pt>
                <c:pt idx="120">
                  <c:v>0.62664898011833436</c:v>
                </c:pt>
                <c:pt idx="121">
                  <c:v>0.61503944315016279</c:v>
                </c:pt>
                <c:pt idx="122">
                  <c:v>0.60357591658830667</c:v>
                </c:pt>
                <c:pt idx="123">
                  <c:v>0.59245492517948151</c:v>
                </c:pt>
                <c:pt idx="124">
                  <c:v>0.5815369342640041</c:v>
                </c:pt>
                <c:pt idx="125">
                  <c:v>0.57076324179768556</c:v>
                </c:pt>
                <c:pt idx="126">
                  <c:v>0.56035926721990104</c:v>
                </c:pt>
                <c:pt idx="127">
                  <c:v>0.55002606222406025</c:v>
                </c:pt>
                <c:pt idx="128">
                  <c:v>0.53993833186104878</c:v>
                </c:pt>
                <c:pt idx="129">
                  <c:v>0.53013670690357684</c:v>
                </c:pt>
                <c:pt idx="130">
                  <c:v>0.52044868651777521</c:v>
                </c:pt>
                <c:pt idx="131">
                  <c:v>0.51094097580760711</c:v>
                </c:pt>
                <c:pt idx="132">
                  <c:v>0.5017228920571507</c:v>
                </c:pt>
                <c:pt idx="133">
                  <c:v>0.49261648448184137</c:v>
                </c:pt>
                <c:pt idx="134">
                  <c:v>0.48365496437996641</c:v>
                </c:pt>
                <c:pt idx="135">
                  <c:v>0.47497951040044434</c:v>
                </c:pt>
                <c:pt idx="136">
                  <c:v>0.46643379457294942</c:v>
                </c:pt>
                <c:pt idx="137">
                  <c:v>0.45802619652822618</c:v>
                </c:pt>
                <c:pt idx="138">
                  <c:v>0.44979955669492477</c:v>
                </c:pt>
                <c:pt idx="139">
                  <c:v>0.44173351487144824</c:v>
                </c:pt>
                <c:pt idx="140">
                  <c:v>0.43387730542570357</c:v>
                </c:pt>
                <c:pt idx="141">
                  <c:v>0.42614719385281213</c:v>
                </c:pt>
                <c:pt idx="142">
                  <c:v>0.41853404175490144</c:v>
                </c:pt>
                <c:pt idx="143">
                  <c:v>0.4111053869780153</c:v>
                </c:pt>
                <c:pt idx="144">
                  <c:v>0.40385247774422178</c:v>
                </c:pt>
                <c:pt idx="145">
                  <c:v>0.3967190951015801</c:v>
                </c:pt>
                <c:pt idx="146">
                  <c:v>0.38970634881407035</c:v>
                </c:pt>
                <c:pt idx="147">
                  <c:v>0.38281206413172192</c:v>
                </c:pt>
                <c:pt idx="148">
                  <c:v>0.37611800456419586</c:v>
                </c:pt>
                <c:pt idx="149">
                  <c:v>0.36952154939994231</c:v>
                </c:pt>
                <c:pt idx="150">
                  <c:v>0.36305274100974211</c:v>
                </c:pt>
                <c:pt idx="151">
                  <c:v>0.35669404546730221</c:v>
                </c:pt>
                <c:pt idx="152">
                  <c:v>0.35044994615949698</c:v>
                </c:pt>
                <c:pt idx="153">
                  <c:v>0.34438636129722017</c:v>
                </c:pt>
                <c:pt idx="154">
                  <c:v>0.33837093132548052</c:v>
                </c:pt>
                <c:pt idx="155">
                  <c:v>0.33249502649530771</c:v>
                </c:pt>
                <c:pt idx="156">
                  <c:v>0.32674626734107737</c:v>
                </c:pt>
                <c:pt idx="157">
                  <c:v>0.32111491746734838</c:v>
                </c:pt>
                <c:pt idx="158">
                  <c:v>0.31556770425755537</c:v>
                </c:pt>
                <c:pt idx="159">
                  <c:v>0.31013679876457906</c:v>
                </c:pt>
                <c:pt idx="160">
                  <c:v>0.30482680602464846</c:v>
                </c:pt>
                <c:pt idx="161">
                  <c:v>0.29959550859872253</c:v>
                </c:pt>
                <c:pt idx="162">
                  <c:v>0.29446674518752847</c:v>
                </c:pt>
                <c:pt idx="163">
                  <c:v>0.28942122580017898</c:v>
                </c:pt>
                <c:pt idx="164">
                  <c:v>0.28446976501028992</c:v>
                </c:pt>
                <c:pt idx="165">
                  <c:v>0.27963707067072385</c:v>
                </c:pt>
                <c:pt idx="166">
                  <c:v>0.2749135903920979</c:v>
                </c:pt>
                <c:pt idx="167">
                  <c:v>0.27025337837636471</c:v>
                </c:pt>
                <c:pt idx="168">
                  <c:v>0.26567158837337046</c:v>
                </c:pt>
                <c:pt idx="169">
                  <c:v>0.26117859563324608</c:v>
                </c:pt>
                <c:pt idx="170">
                  <c:v>0.25679619012400506</c:v>
                </c:pt>
                <c:pt idx="171">
                  <c:v>0.25244902387727058</c:v>
                </c:pt>
                <c:pt idx="172">
                  <c:v>0.24822695527691394</c:v>
                </c:pt>
                <c:pt idx="173">
                  <c:v>0.24403975714463741</c:v>
                </c:pt>
                <c:pt idx="174">
                  <c:v>0.23998215767787773</c:v>
                </c:pt>
                <c:pt idx="175">
                  <c:v>0.23599596932530406</c:v>
                </c:pt>
                <c:pt idx="176">
                  <c:v>0.23203482627170161</c:v>
                </c:pt>
                <c:pt idx="177">
                  <c:v>0.22817737014498563</c:v>
                </c:pt>
                <c:pt idx="178">
                  <c:v>0.22436515451641756</c:v>
                </c:pt>
                <c:pt idx="179">
                  <c:v>0.22065237147500738</c:v>
                </c:pt>
                <c:pt idx="180">
                  <c:v>0.21700624790042644</c:v>
                </c:pt>
                <c:pt idx="181">
                  <c:v>0.21342328167753297</c:v>
                </c:pt>
                <c:pt idx="182">
                  <c:v>0.20989122634287924</c:v>
                </c:pt>
                <c:pt idx="183">
                  <c:v>0.20643531791865827</c:v>
                </c:pt>
                <c:pt idx="184">
                  <c:v>0.20303188163787128</c:v>
                </c:pt>
                <c:pt idx="185">
                  <c:v>0.19972913695732136</c:v>
                </c:pt>
                <c:pt idx="186">
                  <c:v>0.19643194844247777</c:v>
                </c:pt>
                <c:pt idx="187">
                  <c:v>0.19324526556534696</c:v>
                </c:pt>
                <c:pt idx="188">
                  <c:v>0.19007546234992334</c:v>
                </c:pt>
                <c:pt idx="189">
                  <c:v>0.18699530618614527</c:v>
                </c:pt>
                <c:pt idx="190">
                  <c:v>0.18394561971421355</c:v>
                </c:pt>
                <c:pt idx="191">
                  <c:v>0.18095230306615123</c:v>
                </c:pt>
                <c:pt idx="192">
                  <c:v>0.1780379727634136</c:v>
                </c:pt>
                <c:pt idx="193">
                  <c:v>0.17514581471914425</c:v>
                </c:pt>
                <c:pt idx="194">
                  <c:v>0.17232472764560949</c:v>
                </c:pt>
                <c:pt idx="195">
                  <c:v>0.16953359117964284</c:v>
                </c:pt>
                <c:pt idx="196">
                  <c:v>0.16681457589613274</c:v>
                </c:pt>
                <c:pt idx="197">
                  <c:v>0.1641152428684291</c:v>
                </c:pt>
                <c:pt idx="198">
                  <c:v>0.16149354057735768</c:v>
                </c:pt>
                <c:pt idx="199">
                  <c:v>0.159009908183943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7958272"/>
        <c:axId val="177976832"/>
      </c:scatterChart>
      <c:valAx>
        <c:axId val="177958272"/>
        <c:scaling>
          <c:orientation val="minMax"/>
          <c:max val="24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0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00">
                    <a:latin typeface="Times New Roman" pitchFamily="18" charset="0"/>
                    <a:cs typeface="Times New Roman" pitchFamily="18" charset="0"/>
                  </a:rPr>
                  <a:t>Time (h)</a:t>
                </a:r>
              </a:p>
            </c:rich>
          </c:tx>
          <c:layout/>
          <c:overlay val="0"/>
        </c:title>
        <c:numFmt formatCode="General" sourceLinked="0"/>
        <c:majorTickMark val="cross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77976832"/>
        <c:crosses val="autoZero"/>
        <c:crossBetween val="midCat"/>
        <c:majorUnit val="4"/>
      </c:valAx>
      <c:valAx>
        <c:axId val="17797683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 algn="ctr">
                  <a:defRPr sz="10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00">
                    <a:latin typeface="Times New Roman" pitchFamily="18" charset="0"/>
                    <a:cs typeface="Times New Roman" pitchFamily="18" charset="0"/>
                  </a:rPr>
                  <a:t>Systemic Concentration (µg/mL)</a:t>
                </a:r>
              </a:p>
            </c:rich>
          </c:tx>
          <c:layout>
            <c:manualLayout>
              <c:xMode val="edge"/>
              <c:yMode val="edge"/>
              <c:x val="2.6940925862528053E-2"/>
              <c:y val="0.16097926667449652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77958272"/>
        <c:crosses val="autoZero"/>
        <c:crossBetween val="midCat"/>
      </c:valAx>
      <c:spPr>
        <a:solidFill>
          <a:srgbClr val="FFFFFF"/>
        </a:solidFill>
      </c:spPr>
    </c:plotArea>
    <c:legend>
      <c:legendPos val="b"/>
      <c:layout>
        <c:manualLayout>
          <c:xMode val="edge"/>
          <c:yMode val="edge"/>
          <c:x val="0.57810088510952329"/>
          <c:y val="0.13903569658463724"/>
          <c:w val="0.38774555598616284"/>
          <c:h val="0.47392110734093301"/>
        </c:manualLayout>
      </c:layout>
      <c:overlay val="0"/>
      <c:spPr>
        <a:noFill/>
        <a:effectLst>
          <a:outerShdw dist="35921" dir="2700000" algn="br">
            <a:srgbClr val="000000"/>
          </a:outerShdw>
        </a:effectLst>
      </c:spPr>
      <c:txPr>
        <a:bodyPr/>
        <a:lstStyle/>
        <a:p>
          <a:pPr>
            <a:defRPr sz="1000" b="1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49B605-5956-4E5E-902E-C1F9AE26D0B1}" type="datetimeFigureOut">
              <a:rPr lang="en-US" smtClean="0"/>
              <a:t>7/2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617CB7-4046-4612-BD6C-F823D970A3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0806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0D0A6-2369-41BC-8EF4-45C487981C94}" type="datetimeFigureOut">
              <a:rPr lang="en-US" smtClean="0"/>
              <a:t>7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E8670-F54C-4F15-957E-84193495D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61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0D0A6-2369-41BC-8EF4-45C487981C94}" type="datetimeFigureOut">
              <a:rPr lang="en-US" smtClean="0"/>
              <a:t>7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E8670-F54C-4F15-957E-84193495D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141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0D0A6-2369-41BC-8EF4-45C487981C94}" type="datetimeFigureOut">
              <a:rPr lang="en-US" smtClean="0"/>
              <a:t>7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E8670-F54C-4F15-957E-84193495D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270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0D0A6-2369-41BC-8EF4-45C487981C94}" type="datetimeFigureOut">
              <a:rPr lang="en-US" smtClean="0"/>
              <a:t>7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E8670-F54C-4F15-957E-84193495D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249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0D0A6-2369-41BC-8EF4-45C487981C94}" type="datetimeFigureOut">
              <a:rPr lang="en-US" smtClean="0"/>
              <a:t>7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E8670-F54C-4F15-957E-84193495D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695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0D0A6-2369-41BC-8EF4-45C487981C94}" type="datetimeFigureOut">
              <a:rPr lang="en-US" smtClean="0"/>
              <a:t>7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E8670-F54C-4F15-957E-84193495D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078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0D0A6-2369-41BC-8EF4-45C487981C94}" type="datetimeFigureOut">
              <a:rPr lang="en-US" smtClean="0"/>
              <a:t>7/2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E8670-F54C-4F15-957E-84193495D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6008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0D0A6-2369-41BC-8EF4-45C487981C94}" type="datetimeFigureOut">
              <a:rPr lang="en-US" smtClean="0"/>
              <a:t>7/2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E8670-F54C-4F15-957E-84193495D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2240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0D0A6-2369-41BC-8EF4-45C487981C94}" type="datetimeFigureOut">
              <a:rPr lang="en-US" smtClean="0"/>
              <a:t>7/2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E8670-F54C-4F15-957E-84193495D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273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0D0A6-2369-41BC-8EF4-45C487981C94}" type="datetimeFigureOut">
              <a:rPr lang="en-US" smtClean="0"/>
              <a:t>7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E8670-F54C-4F15-957E-84193495D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036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0D0A6-2369-41BC-8EF4-45C487981C94}" type="datetimeFigureOut">
              <a:rPr lang="en-US" smtClean="0"/>
              <a:t>7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E8670-F54C-4F15-957E-84193495D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437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20D0A6-2369-41BC-8EF4-45C487981C94}" type="datetimeFigureOut">
              <a:rPr lang="en-US" smtClean="0"/>
              <a:t>7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5E8670-F54C-4F15-957E-84193495D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495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chart" Target="../charts/chart2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ÙØªÙØ¬Ø© Ø¨Ø­Ø« Ø§ÙØµÙØ± Ø¹Ù âªrotavapâ¬â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94" t="2439" r="15094"/>
          <a:stretch>
            <a:fillRect/>
          </a:stretch>
        </p:blipFill>
        <p:spPr bwMode="auto">
          <a:xfrm>
            <a:off x="216877" y="228600"/>
            <a:ext cx="2602523" cy="2438400"/>
          </a:xfrm>
          <a:prstGeom prst="rect">
            <a:avLst/>
          </a:prstGeom>
          <a:ln>
            <a:noFill/>
          </a:ln>
          <a:effectLst>
            <a:softEdge rad="112500"/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ounded Rectangle 4"/>
          <p:cNvSpPr/>
          <p:nvPr/>
        </p:nvSpPr>
        <p:spPr>
          <a:xfrm>
            <a:off x="1160834" y="2612717"/>
            <a:ext cx="1353766" cy="511483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tary evaporator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Notched Right Arrow 5"/>
          <p:cNvSpPr/>
          <p:nvPr/>
        </p:nvSpPr>
        <p:spPr>
          <a:xfrm>
            <a:off x="2660515" y="1600200"/>
            <a:ext cx="1149485" cy="228159"/>
          </a:xfrm>
          <a:prstGeom prst="notch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lum bright="20000" contrast="40000"/>
          </a:blip>
          <a:srcRect l="10236"/>
          <a:stretch/>
        </p:blipFill>
        <p:spPr>
          <a:xfrm>
            <a:off x="4016157" y="1031080"/>
            <a:ext cx="1165443" cy="1484250"/>
          </a:xfrm>
          <a:prstGeom prst="ellipse">
            <a:avLst/>
          </a:prstGeom>
          <a:ln>
            <a:noFill/>
          </a:ln>
          <a:effectLst>
            <a:softEdge rad="112500"/>
          </a:effectLst>
        </p:spPr>
      </p:pic>
      <p:sp>
        <p:nvSpPr>
          <p:cNvPr id="8" name="Rounded Rectangle 7"/>
          <p:cNvSpPr/>
          <p:nvPr/>
        </p:nvSpPr>
        <p:spPr>
          <a:xfrm>
            <a:off x="3810000" y="2590800"/>
            <a:ext cx="1447800" cy="533400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lid mass of DCN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4" descr="ØµÙØ±Ø© Ø°Ø§Øª ØµÙØ©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10000" r="9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34200" y="799878"/>
            <a:ext cx="1447800" cy="16772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ounded Rectangle 10"/>
          <p:cNvSpPr/>
          <p:nvPr/>
        </p:nvSpPr>
        <p:spPr>
          <a:xfrm>
            <a:off x="6858000" y="2514600"/>
            <a:ext cx="1600200" cy="511483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ld dispersion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DCN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ounded Rectangle 11"/>
          <p:cNvSpPr/>
          <p:nvPr/>
        </p:nvSpPr>
        <p:spPr>
          <a:xfrm>
            <a:off x="3276600" y="128200"/>
            <a:ext cx="2362200" cy="633800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aphical abstract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Chart 12"/>
          <p:cNvGraphicFramePr/>
          <p:nvPr>
            <p:extLst>
              <p:ext uri="{D42A27DB-BD31-4B8C-83A1-F6EECF244321}">
                <p14:modId xmlns:p14="http://schemas.microsoft.com/office/powerpoint/2010/main" val="1592984156"/>
              </p:ext>
            </p:extLst>
          </p:nvPr>
        </p:nvGraphicFramePr>
        <p:xfrm>
          <a:off x="5736492" y="3842429"/>
          <a:ext cx="3276600" cy="2079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Chart 13"/>
          <p:cNvGraphicFramePr/>
          <p:nvPr>
            <p:extLst>
              <p:ext uri="{D42A27DB-BD31-4B8C-83A1-F6EECF244321}">
                <p14:modId xmlns:p14="http://schemas.microsoft.com/office/powerpoint/2010/main" val="1999642067"/>
              </p:ext>
            </p:extLst>
          </p:nvPr>
        </p:nvGraphicFramePr>
        <p:xfrm>
          <a:off x="0" y="3352800"/>
          <a:ext cx="5257800" cy="27167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5" name="Notched Right Arrow 14"/>
          <p:cNvSpPr/>
          <p:nvPr/>
        </p:nvSpPr>
        <p:spPr>
          <a:xfrm>
            <a:off x="5428034" y="1638520"/>
            <a:ext cx="1506165" cy="189839"/>
          </a:xfrm>
          <a:prstGeom prst="notch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sp>
        <p:nvSpPr>
          <p:cNvPr id="16" name="Notched Right Arrow 15"/>
          <p:cNvSpPr/>
          <p:nvPr/>
        </p:nvSpPr>
        <p:spPr>
          <a:xfrm rot="10800000">
            <a:off x="5287405" y="5029200"/>
            <a:ext cx="449087" cy="110098"/>
          </a:xfrm>
          <a:prstGeom prst="notch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sp>
        <p:nvSpPr>
          <p:cNvPr id="17" name="Notched Right Arrow 16"/>
          <p:cNvSpPr/>
          <p:nvPr/>
        </p:nvSpPr>
        <p:spPr>
          <a:xfrm rot="5400000">
            <a:off x="7447715" y="3485317"/>
            <a:ext cx="514886" cy="134485"/>
          </a:xfrm>
          <a:prstGeom prst="notch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sp>
        <p:nvSpPr>
          <p:cNvPr id="18" name="Rounded Rectangle 17"/>
          <p:cNvSpPr/>
          <p:nvPr/>
        </p:nvSpPr>
        <p:spPr>
          <a:xfrm>
            <a:off x="6553200" y="6019800"/>
            <a:ext cx="1905000" cy="533400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tro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issolution study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ounded Rectangle 18"/>
          <p:cNvSpPr/>
          <p:nvPr/>
        </p:nvSpPr>
        <p:spPr>
          <a:xfrm>
            <a:off x="1905000" y="6019800"/>
            <a:ext cx="1905000" cy="533400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PK modeling 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ounded Rectangle 19"/>
          <p:cNvSpPr/>
          <p:nvPr/>
        </p:nvSpPr>
        <p:spPr>
          <a:xfrm>
            <a:off x="2558374" y="1031080"/>
            <a:ext cx="1353766" cy="511483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lvent evaporation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ounded Rectangle 20"/>
          <p:cNvSpPr/>
          <p:nvPr/>
        </p:nvSpPr>
        <p:spPr>
          <a:xfrm>
            <a:off x="5334000" y="1012517"/>
            <a:ext cx="1582366" cy="511483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ushing/</a:t>
            </a:r>
            <a:r>
              <a:rPr lang="en-US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iving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9748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</TotalTime>
  <Words>36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hinazeamry9@gmail.com</dc:creator>
  <cp:lastModifiedBy>shahinazeamry9@gmail.com</cp:lastModifiedBy>
  <cp:revision>6</cp:revision>
  <dcterms:created xsi:type="dcterms:W3CDTF">2020-07-23T09:40:40Z</dcterms:created>
  <dcterms:modified xsi:type="dcterms:W3CDTF">2020-07-23T10:50:03Z</dcterms:modified>
</cp:coreProperties>
</file>